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80" r:id="rId4"/>
    <p:sldId id="281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x Lam" initials="ML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319D9"/>
    <a:srgbClr val="E6CB0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829" autoAdjust="0"/>
    <p:restoredTop sz="78993" autoAdjust="0"/>
  </p:normalViewPr>
  <p:slideViewPr>
    <p:cSldViewPr showGuides="1">
      <p:cViewPr>
        <p:scale>
          <a:sx n="100" d="100"/>
          <a:sy n="100" d="100"/>
        </p:scale>
        <p:origin x="-1518" y="2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COGENT\COGENT_SCZ_EDU\ASSET_genomewide\COGENT_ASSET\ManhattanQQPlots\Consolidated_tissueexp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5744225721784798"/>
          <c:y val="1.7605764888004499E-2"/>
          <c:w val="0.493724555263925"/>
          <c:h val="0.906458641522772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Consolidated_tissueexp!$H$1</c:f>
              <c:strCache>
                <c:ptCount val="1"/>
                <c:pt idx="0">
                  <c:v>ALL </c:v>
                </c:pt>
              </c:strCache>
            </c:strRef>
          </c:tx>
          <c:invertIfNegative val="0"/>
          <c:cat>
            <c:strRef>
              <c:f>Consolidated_tissueexp!$A$3:$A$55</c:f>
              <c:strCache>
                <c:ptCount val="53"/>
                <c:pt idx="0">
                  <c:v>Adipose_Subcutaneous</c:v>
                </c:pt>
                <c:pt idx="1">
                  <c:v>Adipose_Visceral_Omentum</c:v>
                </c:pt>
                <c:pt idx="2">
                  <c:v>Adrenal_Gland</c:v>
                </c:pt>
                <c:pt idx="3">
                  <c:v>Artery_Aorta</c:v>
                </c:pt>
                <c:pt idx="4">
                  <c:v>Artery_Coronary</c:v>
                </c:pt>
                <c:pt idx="5">
                  <c:v>Artery_Tibial</c:v>
                </c:pt>
                <c:pt idx="6">
                  <c:v>Bladder</c:v>
                </c:pt>
                <c:pt idx="7">
                  <c:v>Brain_Amygdala</c:v>
                </c:pt>
                <c:pt idx="8">
                  <c:v>Brain_Anterior_cingulate_cortex_BA24</c:v>
                </c:pt>
                <c:pt idx="9">
                  <c:v>Brain_Caudate_basal_ganglia</c:v>
                </c:pt>
                <c:pt idx="10">
                  <c:v>Brain_Cerebellar_Hemisphere</c:v>
                </c:pt>
                <c:pt idx="11">
                  <c:v>Brain_Cerebellum</c:v>
                </c:pt>
                <c:pt idx="12">
                  <c:v>Brain_Cortex</c:v>
                </c:pt>
                <c:pt idx="13">
                  <c:v>Brain_Frontal_Cortex_BA9</c:v>
                </c:pt>
                <c:pt idx="14">
                  <c:v>Brain_Hippocampus</c:v>
                </c:pt>
                <c:pt idx="15">
                  <c:v>Brain_Hypothalamus</c:v>
                </c:pt>
                <c:pt idx="16">
                  <c:v>Brain_Nucleus_accumbens_basal_ganglia</c:v>
                </c:pt>
                <c:pt idx="17">
                  <c:v>Brain_Putamen_basal_ganglia</c:v>
                </c:pt>
                <c:pt idx="18">
                  <c:v>Brain_Spinal_cord_cervical_c.1</c:v>
                </c:pt>
                <c:pt idx="19">
                  <c:v>Brain_Substantia_nigra</c:v>
                </c:pt>
                <c:pt idx="20">
                  <c:v>Breast_Mammary_Tissue</c:v>
                </c:pt>
                <c:pt idx="21">
                  <c:v>Cells_EBV.transformed_lymphocytes</c:v>
                </c:pt>
                <c:pt idx="22">
                  <c:v>Cells_Transformed_fibroblasts</c:v>
                </c:pt>
                <c:pt idx="23">
                  <c:v>Cervix_Ectocervix</c:v>
                </c:pt>
                <c:pt idx="24">
                  <c:v>Cervix_Endocervix</c:v>
                </c:pt>
                <c:pt idx="25">
                  <c:v>Colon_Sigmoid</c:v>
                </c:pt>
                <c:pt idx="26">
                  <c:v>Colon_Transverse</c:v>
                </c:pt>
                <c:pt idx="27">
                  <c:v>Esophagus_Gastroesophageal_Junction</c:v>
                </c:pt>
                <c:pt idx="28">
                  <c:v>Esophagus_Mucosa</c:v>
                </c:pt>
                <c:pt idx="29">
                  <c:v>Esophagus_Muscularis</c:v>
                </c:pt>
                <c:pt idx="30">
                  <c:v>Fallopian_Tube</c:v>
                </c:pt>
                <c:pt idx="31">
                  <c:v>Heart_Atrial_Appendage</c:v>
                </c:pt>
                <c:pt idx="32">
                  <c:v>Heart_Left_Ventricle</c:v>
                </c:pt>
                <c:pt idx="33">
                  <c:v>Kidney_Cortex</c:v>
                </c:pt>
                <c:pt idx="34">
                  <c:v>Liver</c:v>
                </c:pt>
                <c:pt idx="35">
                  <c:v>Lung</c:v>
                </c:pt>
                <c:pt idx="36">
                  <c:v>Minor_Salivary_Gland</c:v>
                </c:pt>
                <c:pt idx="37">
                  <c:v>Muscle_Skeletal</c:v>
                </c:pt>
                <c:pt idx="38">
                  <c:v>Nerve_Tibial</c:v>
                </c:pt>
                <c:pt idx="39">
                  <c:v>Ovary</c:v>
                </c:pt>
                <c:pt idx="40">
                  <c:v>Pancreas</c:v>
                </c:pt>
                <c:pt idx="41">
                  <c:v>Pituitary</c:v>
                </c:pt>
                <c:pt idx="42">
                  <c:v>Prostate</c:v>
                </c:pt>
                <c:pt idx="43">
                  <c:v>Skin_Not_Sun_Exposed_Suprapubic</c:v>
                </c:pt>
                <c:pt idx="44">
                  <c:v>Skin_Sun_Exposed_Lower_leg</c:v>
                </c:pt>
                <c:pt idx="45">
                  <c:v>Small_Intestine_Terminal_Ileum</c:v>
                </c:pt>
                <c:pt idx="46">
                  <c:v>Spleen</c:v>
                </c:pt>
                <c:pt idx="47">
                  <c:v>Stomach</c:v>
                </c:pt>
                <c:pt idx="48">
                  <c:v>Testis</c:v>
                </c:pt>
                <c:pt idx="49">
                  <c:v>Thyroid</c:v>
                </c:pt>
                <c:pt idx="50">
                  <c:v>Uterus</c:v>
                </c:pt>
                <c:pt idx="51">
                  <c:v>Vagina</c:v>
                </c:pt>
                <c:pt idx="52">
                  <c:v>Whole_Blood</c:v>
                </c:pt>
              </c:strCache>
            </c:strRef>
          </c:cat>
          <c:val>
            <c:numRef>
              <c:f>Consolidated_tissueexp!$H$3:$H$55</c:f>
              <c:numCache>
                <c:formatCode>General</c:formatCode>
                <c:ptCount val="53"/>
                <c:pt idx="0">
                  <c:v>2.6058450675510989E-5</c:v>
                </c:pt>
                <c:pt idx="1">
                  <c:v>4.3429665338816141E-6</c:v>
                </c:pt>
                <c:pt idx="2">
                  <c:v>3.2742274391581554E-2</c:v>
                </c:pt>
                <c:pt idx="3">
                  <c:v>1.6273063255449322E-3</c:v>
                </c:pt>
                <c:pt idx="4">
                  <c:v>4.0842880461536599E-4</c:v>
                </c:pt>
                <c:pt idx="5">
                  <c:v>1.3031310841759016E-2</c:v>
                </c:pt>
                <c:pt idx="6">
                  <c:v>7.539271165210578E-3</c:v>
                </c:pt>
                <c:pt idx="7">
                  <c:v>8.2270844789352928</c:v>
                </c:pt>
                <c:pt idx="8">
                  <c:v>12.292327648985252</c:v>
                </c:pt>
                <c:pt idx="9">
                  <c:v>8.7353238178511763</c:v>
                </c:pt>
                <c:pt idx="10">
                  <c:v>18.924270600259103</c:v>
                </c:pt>
                <c:pt idx="11">
                  <c:v>18.090599103634883</c:v>
                </c:pt>
                <c:pt idx="12">
                  <c:v>13.826376742301919</c:v>
                </c:pt>
                <c:pt idx="13">
                  <c:v>14.622675532263445</c:v>
                </c:pt>
                <c:pt idx="14">
                  <c:v>9.1909927629445693</c:v>
                </c:pt>
                <c:pt idx="15">
                  <c:v>8.0982039648007902</c:v>
                </c:pt>
                <c:pt idx="16">
                  <c:v>10.571476459579236</c:v>
                </c:pt>
                <c:pt idx="17">
                  <c:v>8.450959934916531</c:v>
                </c:pt>
                <c:pt idx="18">
                  <c:v>3.0139990384858297</c:v>
                </c:pt>
                <c:pt idx="19">
                  <c:v>4.3477052992747955</c:v>
                </c:pt>
                <c:pt idx="20">
                  <c:v>4.3429665338816141E-6</c:v>
                </c:pt>
                <c:pt idx="21">
                  <c:v>0.67050042423715717</c:v>
                </c:pt>
                <c:pt idx="22">
                  <c:v>1.7751387053767439E-2</c:v>
                </c:pt>
                <c:pt idx="23">
                  <c:v>2.8627291427582844E-3</c:v>
                </c:pt>
                <c:pt idx="24">
                  <c:v>2.3515451037938442E-3</c:v>
                </c:pt>
                <c:pt idx="25">
                  <c:v>7.4925236353145255E-2</c:v>
                </c:pt>
                <c:pt idx="26">
                  <c:v>8.7739243075051505E-3</c:v>
                </c:pt>
                <c:pt idx="27">
                  <c:v>2.0415207998335981E-2</c:v>
                </c:pt>
                <c:pt idx="28">
                  <c:v>1.6071869309628963E-4</c:v>
                </c:pt>
                <c:pt idx="29">
                  <c:v>2.8084316851971179E-2</c:v>
                </c:pt>
                <c:pt idx="30">
                  <c:v>2.3023709362944382E-4</c:v>
                </c:pt>
                <c:pt idx="31">
                  <c:v>9.5214789828374522E-4</c:v>
                </c:pt>
                <c:pt idx="32">
                  <c:v>9.6085293901171126E-4</c:v>
                </c:pt>
                <c:pt idx="33">
                  <c:v>6.0805483949666899E-5</c:v>
                </c:pt>
                <c:pt idx="34">
                  <c:v>1.3465216155356954E-4</c:v>
                </c:pt>
                <c:pt idx="35">
                  <c:v>0</c:v>
                </c:pt>
                <c:pt idx="36">
                  <c:v>4.3429665338816141E-6</c:v>
                </c:pt>
                <c:pt idx="37">
                  <c:v>5.4221315260643679E-2</c:v>
                </c:pt>
                <c:pt idx="38">
                  <c:v>5.1991007053961312E-3</c:v>
                </c:pt>
                <c:pt idx="39">
                  <c:v>3.2915580934904785E-2</c:v>
                </c:pt>
                <c:pt idx="40">
                  <c:v>6.7802839152598276E-4</c:v>
                </c:pt>
                <c:pt idx="41">
                  <c:v>3.6070921047066058</c:v>
                </c:pt>
                <c:pt idx="42">
                  <c:v>6.2148557729154504E-4</c:v>
                </c:pt>
                <c:pt idx="43">
                  <c:v>1.0130868478760507E-3</c:v>
                </c:pt>
                <c:pt idx="44">
                  <c:v>5.9974030107876931E-4</c:v>
                </c:pt>
                <c:pt idx="45">
                  <c:v>5.9425336114274988E-3</c:v>
                </c:pt>
                <c:pt idx="46">
                  <c:v>1.4138102439906299E-2</c:v>
                </c:pt>
                <c:pt idx="47">
                  <c:v>2.3023709362944382E-4</c:v>
                </c:pt>
                <c:pt idx="48">
                  <c:v>0.71179550324847718</c:v>
                </c:pt>
                <c:pt idx="49">
                  <c:v>1.302902989351207E-5</c:v>
                </c:pt>
                <c:pt idx="50">
                  <c:v>1.9801126220023495E-2</c:v>
                </c:pt>
                <c:pt idx="51">
                  <c:v>3.3888187700458465E-4</c:v>
                </c:pt>
                <c:pt idx="52">
                  <c:v>4.7905312331979859E-2</c:v>
                </c:pt>
              </c:numCache>
            </c:numRef>
          </c:val>
        </c:ser>
        <c:ser>
          <c:idx val="2"/>
          <c:order val="1"/>
          <c:tx>
            <c:strRef>
              <c:f>Consolidated_tissueexp!$J$1</c:f>
              <c:strCache>
                <c:ptCount val="1"/>
                <c:pt idx="0">
                  <c:v>SZ outlier</c:v>
                </c:pt>
              </c:strCache>
            </c:strRef>
          </c:tx>
          <c:invertIfNegative val="0"/>
          <c:cat>
            <c:strRef>
              <c:f>Consolidated_tissueexp!$A$3:$A$55</c:f>
              <c:strCache>
                <c:ptCount val="53"/>
                <c:pt idx="0">
                  <c:v>Adipose_Subcutaneous</c:v>
                </c:pt>
                <c:pt idx="1">
                  <c:v>Adipose_Visceral_Omentum</c:v>
                </c:pt>
                <c:pt idx="2">
                  <c:v>Adrenal_Gland</c:v>
                </c:pt>
                <c:pt idx="3">
                  <c:v>Artery_Aorta</c:v>
                </c:pt>
                <c:pt idx="4">
                  <c:v>Artery_Coronary</c:v>
                </c:pt>
                <c:pt idx="5">
                  <c:v>Artery_Tibial</c:v>
                </c:pt>
                <c:pt idx="6">
                  <c:v>Bladder</c:v>
                </c:pt>
                <c:pt idx="7">
                  <c:v>Brain_Amygdala</c:v>
                </c:pt>
                <c:pt idx="8">
                  <c:v>Brain_Anterior_cingulate_cortex_BA24</c:v>
                </c:pt>
                <c:pt idx="9">
                  <c:v>Brain_Caudate_basal_ganglia</c:v>
                </c:pt>
                <c:pt idx="10">
                  <c:v>Brain_Cerebellar_Hemisphere</c:v>
                </c:pt>
                <c:pt idx="11">
                  <c:v>Brain_Cerebellum</c:v>
                </c:pt>
                <c:pt idx="12">
                  <c:v>Brain_Cortex</c:v>
                </c:pt>
                <c:pt idx="13">
                  <c:v>Brain_Frontal_Cortex_BA9</c:v>
                </c:pt>
                <c:pt idx="14">
                  <c:v>Brain_Hippocampus</c:v>
                </c:pt>
                <c:pt idx="15">
                  <c:v>Brain_Hypothalamus</c:v>
                </c:pt>
                <c:pt idx="16">
                  <c:v>Brain_Nucleus_accumbens_basal_ganglia</c:v>
                </c:pt>
                <c:pt idx="17">
                  <c:v>Brain_Putamen_basal_ganglia</c:v>
                </c:pt>
                <c:pt idx="18">
                  <c:v>Brain_Spinal_cord_cervical_c.1</c:v>
                </c:pt>
                <c:pt idx="19">
                  <c:v>Brain_Substantia_nigra</c:v>
                </c:pt>
                <c:pt idx="20">
                  <c:v>Breast_Mammary_Tissue</c:v>
                </c:pt>
                <c:pt idx="21">
                  <c:v>Cells_EBV.transformed_lymphocytes</c:v>
                </c:pt>
                <c:pt idx="22">
                  <c:v>Cells_Transformed_fibroblasts</c:v>
                </c:pt>
                <c:pt idx="23">
                  <c:v>Cervix_Ectocervix</c:v>
                </c:pt>
                <c:pt idx="24">
                  <c:v>Cervix_Endocervix</c:v>
                </c:pt>
                <c:pt idx="25">
                  <c:v>Colon_Sigmoid</c:v>
                </c:pt>
                <c:pt idx="26">
                  <c:v>Colon_Transverse</c:v>
                </c:pt>
                <c:pt idx="27">
                  <c:v>Esophagus_Gastroesophageal_Junction</c:v>
                </c:pt>
                <c:pt idx="28">
                  <c:v>Esophagus_Mucosa</c:v>
                </c:pt>
                <c:pt idx="29">
                  <c:v>Esophagus_Muscularis</c:v>
                </c:pt>
                <c:pt idx="30">
                  <c:v>Fallopian_Tube</c:v>
                </c:pt>
                <c:pt idx="31">
                  <c:v>Heart_Atrial_Appendage</c:v>
                </c:pt>
                <c:pt idx="32">
                  <c:v>Heart_Left_Ventricle</c:v>
                </c:pt>
                <c:pt idx="33">
                  <c:v>Kidney_Cortex</c:v>
                </c:pt>
                <c:pt idx="34">
                  <c:v>Liver</c:v>
                </c:pt>
                <c:pt idx="35">
                  <c:v>Lung</c:v>
                </c:pt>
                <c:pt idx="36">
                  <c:v>Minor_Salivary_Gland</c:v>
                </c:pt>
                <c:pt idx="37">
                  <c:v>Muscle_Skeletal</c:v>
                </c:pt>
                <c:pt idx="38">
                  <c:v>Nerve_Tibial</c:v>
                </c:pt>
                <c:pt idx="39">
                  <c:v>Ovary</c:v>
                </c:pt>
                <c:pt idx="40">
                  <c:v>Pancreas</c:v>
                </c:pt>
                <c:pt idx="41">
                  <c:v>Pituitary</c:v>
                </c:pt>
                <c:pt idx="42">
                  <c:v>Prostate</c:v>
                </c:pt>
                <c:pt idx="43">
                  <c:v>Skin_Not_Sun_Exposed_Suprapubic</c:v>
                </c:pt>
                <c:pt idx="44">
                  <c:v>Skin_Sun_Exposed_Lower_leg</c:v>
                </c:pt>
                <c:pt idx="45">
                  <c:v>Small_Intestine_Terminal_Ileum</c:v>
                </c:pt>
                <c:pt idx="46">
                  <c:v>Spleen</c:v>
                </c:pt>
                <c:pt idx="47">
                  <c:v>Stomach</c:v>
                </c:pt>
                <c:pt idx="48">
                  <c:v>Testis</c:v>
                </c:pt>
                <c:pt idx="49">
                  <c:v>Thyroid</c:v>
                </c:pt>
                <c:pt idx="50">
                  <c:v>Uterus</c:v>
                </c:pt>
                <c:pt idx="51">
                  <c:v>Vagina</c:v>
                </c:pt>
                <c:pt idx="52">
                  <c:v>Whole_Blood</c:v>
                </c:pt>
              </c:strCache>
            </c:strRef>
          </c:cat>
          <c:val>
            <c:numRef>
              <c:f>Consolidated_tissueexp!$J$3:$J$55</c:f>
              <c:numCache>
                <c:formatCode>General</c:formatCode>
                <c:ptCount val="53"/>
                <c:pt idx="0">
                  <c:v>0</c:v>
                </c:pt>
                <c:pt idx="1">
                  <c:v>0</c:v>
                </c:pt>
                <c:pt idx="2">
                  <c:v>2.238612507310454E-2</c:v>
                </c:pt>
                <c:pt idx="3">
                  <c:v>1.0424318533945632E-4</c:v>
                </c:pt>
                <c:pt idx="4">
                  <c:v>5.2118464998839961E-5</c:v>
                </c:pt>
                <c:pt idx="5">
                  <c:v>1.143699111843679E-3</c:v>
                </c:pt>
                <c:pt idx="6">
                  <c:v>3.5321097382827633E-3</c:v>
                </c:pt>
                <c:pt idx="7">
                  <c:v>10.517841304588723</c:v>
                </c:pt>
                <c:pt idx="8">
                  <c:v>14.546330084934773</c:v>
                </c:pt>
                <c:pt idx="9">
                  <c:v>8.973385032065325</c:v>
                </c:pt>
                <c:pt idx="10">
                  <c:v>17.894455754253428</c:v>
                </c:pt>
                <c:pt idx="11">
                  <c:v>17.629931239349947</c:v>
                </c:pt>
                <c:pt idx="12">
                  <c:v>16.233773106425833</c:v>
                </c:pt>
                <c:pt idx="13">
                  <c:v>16.590607969380848</c:v>
                </c:pt>
                <c:pt idx="14">
                  <c:v>11.880513164435364</c:v>
                </c:pt>
                <c:pt idx="15">
                  <c:v>9.4906899257907096</c:v>
                </c:pt>
                <c:pt idx="16">
                  <c:v>10.768224676024905</c:v>
                </c:pt>
                <c:pt idx="17">
                  <c:v>8.8433902818343011</c:v>
                </c:pt>
                <c:pt idx="18">
                  <c:v>4.0288680119339304</c:v>
                </c:pt>
                <c:pt idx="19">
                  <c:v>6.0062464316351285</c:v>
                </c:pt>
                <c:pt idx="20">
                  <c:v>0</c:v>
                </c:pt>
                <c:pt idx="21">
                  <c:v>0.6424844113849032</c:v>
                </c:pt>
                <c:pt idx="22">
                  <c:v>5.806068917770457E-3</c:v>
                </c:pt>
                <c:pt idx="23">
                  <c:v>7.8678526790588207E-4</c:v>
                </c:pt>
                <c:pt idx="24">
                  <c:v>5.6929874343806153E-4</c:v>
                </c:pt>
                <c:pt idx="25">
                  <c:v>3.4610129784877659E-2</c:v>
                </c:pt>
                <c:pt idx="26">
                  <c:v>1.6709009975787279E-3</c:v>
                </c:pt>
                <c:pt idx="27">
                  <c:v>1.2266719491167767E-2</c:v>
                </c:pt>
                <c:pt idx="28">
                  <c:v>6.7367868291003596E-4</c:v>
                </c:pt>
                <c:pt idx="29">
                  <c:v>1.5886926556722542E-2</c:v>
                </c:pt>
                <c:pt idx="30">
                  <c:v>2.1720154586423186E-4</c:v>
                </c:pt>
                <c:pt idx="31">
                  <c:v>2.3602782396974493E-3</c:v>
                </c:pt>
                <c:pt idx="32">
                  <c:v>1.7275806142092618E-3</c:v>
                </c:pt>
                <c:pt idx="33">
                  <c:v>9.9899219688431157E-5</c:v>
                </c:pt>
                <c:pt idx="34">
                  <c:v>7.1717772961138579E-4</c:v>
                </c:pt>
                <c:pt idx="35">
                  <c:v>0</c:v>
                </c:pt>
                <c:pt idx="36">
                  <c:v>0</c:v>
                </c:pt>
                <c:pt idx="37">
                  <c:v>2.14360484191101E-2</c:v>
                </c:pt>
                <c:pt idx="38">
                  <c:v>4.8233462017804456E-4</c:v>
                </c:pt>
                <c:pt idx="39">
                  <c:v>1.9419468650031621E-2</c:v>
                </c:pt>
                <c:pt idx="40">
                  <c:v>3.6496066974871032E-4</c:v>
                </c:pt>
                <c:pt idx="41">
                  <c:v>2.9615388038214365</c:v>
                </c:pt>
                <c:pt idx="42">
                  <c:v>7.5633059711954461E-4</c:v>
                </c:pt>
                <c:pt idx="43">
                  <c:v>1.143699111843679E-3</c:v>
                </c:pt>
                <c:pt idx="44">
                  <c:v>4.6494388499822981E-4</c:v>
                </c:pt>
                <c:pt idx="45">
                  <c:v>9.3909066434185373E-4</c:v>
                </c:pt>
                <c:pt idx="46">
                  <c:v>2.3750924783278917E-2</c:v>
                </c:pt>
                <c:pt idx="47">
                  <c:v>3.0401677804371531E-5</c:v>
                </c:pt>
                <c:pt idx="48">
                  <c:v>0.36698627662845584</c:v>
                </c:pt>
                <c:pt idx="49">
                  <c:v>8.6859764981282404E-6</c:v>
                </c:pt>
                <c:pt idx="50">
                  <c:v>4.8783660448882896E-3</c:v>
                </c:pt>
                <c:pt idx="51">
                  <c:v>4.5190129060307719E-4</c:v>
                </c:pt>
                <c:pt idx="52">
                  <c:v>6.1700479917116358E-2</c:v>
                </c:pt>
              </c:numCache>
            </c:numRef>
          </c:val>
        </c:ser>
        <c:ser>
          <c:idx val="1"/>
          <c:order val="2"/>
          <c:tx>
            <c:strRef>
              <c:f>Consolidated_tissueexp!$I$1</c:f>
              <c:strCache>
                <c:ptCount val="1"/>
                <c:pt idx="0">
                  <c:v>Concordant</c:v>
                </c:pt>
              </c:strCache>
            </c:strRef>
          </c:tx>
          <c:invertIfNegative val="0"/>
          <c:cat>
            <c:strRef>
              <c:f>Consolidated_tissueexp!$A$3:$A$55</c:f>
              <c:strCache>
                <c:ptCount val="53"/>
                <c:pt idx="0">
                  <c:v>Adipose_Subcutaneous</c:v>
                </c:pt>
                <c:pt idx="1">
                  <c:v>Adipose_Visceral_Omentum</c:v>
                </c:pt>
                <c:pt idx="2">
                  <c:v>Adrenal_Gland</c:v>
                </c:pt>
                <c:pt idx="3">
                  <c:v>Artery_Aorta</c:v>
                </c:pt>
                <c:pt idx="4">
                  <c:v>Artery_Coronary</c:v>
                </c:pt>
                <c:pt idx="5">
                  <c:v>Artery_Tibial</c:v>
                </c:pt>
                <c:pt idx="6">
                  <c:v>Bladder</c:v>
                </c:pt>
                <c:pt idx="7">
                  <c:v>Brain_Amygdala</c:v>
                </c:pt>
                <c:pt idx="8">
                  <c:v>Brain_Anterior_cingulate_cortex_BA24</c:v>
                </c:pt>
                <c:pt idx="9">
                  <c:v>Brain_Caudate_basal_ganglia</c:v>
                </c:pt>
                <c:pt idx="10">
                  <c:v>Brain_Cerebellar_Hemisphere</c:v>
                </c:pt>
                <c:pt idx="11">
                  <c:v>Brain_Cerebellum</c:v>
                </c:pt>
                <c:pt idx="12">
                  <c:v>Brain_Cortex</c:v>
                </c:pt>
                <c:pt idx="13">
                  <c:v>Brain_Frontal_Cortex_BA9</c:v>
                </c:pt>
                <c:pt idx="14">
                  <c:v>Brain_Hippocampus</c:v>
                </c:pt>
                <c:pt idx="15">
                  <c:v>Brain_Hypothalamus</c:v>
                </c:pt>
                <c:pt idx="16">
                  <c:v>Brain_Nucleus_accumbens_basal_ganglia</c:v>
                </c:pt>
                <c:pt idx="17">
                  <c:v>Brain_Putamen_basal_ganglia</c:v>
                </c:pt>
                <c:pt idx="18">
                  <c:v>Brain_Spinal_cord_cervical_c.1</c:v>
                </c:pt>
                <c:pt idx="19">
                  <c:v>Brain_Substantia_nigra</c:v>
                </c:pt>
                <c:pt idx="20">
                  <c:v>Breast_Mammary_Tissue</c:v>
                </c:pt>
                <c:pt idx="21">
                  <c:v>Cells_EBV.transformed_lymphocytes</c:v>
                </c:pt>
                <c:pt idx="22">
                  <c:v>Cells_Transformed_fibroblasts</c:v>
                </c:pt>
                <c:pt idx="23">
                  <c:v>Cervix_Ectocervix</c:v>
                </c:pt>
                <c:pt idx="24">
                  <c:v>Cervix_Endocervix</c:v>
                </c:pt>
                <c:pt idx="25">
                  <c:v>Colon_Sigmoid</c:v>
                </c:pt>
                <c:pt idx="26">
                  <c:v>Colon_Transverse</c:v>
                </c:pt>
                <c:pt idx="27">
                  <c:v>Esophagus_Gastroesophageal_Junction</c:v>
                </c:pt>
                <c:pt idx="28">
                  <c:v>Esophagus_Mucosa</c:v>
                </c:pt>
                <c:pt idx="29">
                  <c:v>Esophagus_Muscularis</c:v>
                </c:pt>
                <c:pt idx="30">
                  <c:v>Fallopian_Tube</c:v>
                </c:pt>
                <c:pt idx="31">
                  <c:v>Heart_Atrial_Appendage</c:v>
                </c:pt>
                <c:pt idx="32">
                  <c:v>Heart_Left_Ventricle</c:v>
                </c:pt>
                <c:pt idx="33">
                  <c:v>Kidney_Cortex</c:v>
                </c:pt>
                <c:pt idx="34">
                  <c:v>Liver</c:v>
                </c:pt>
                <c:pt idx="35">
                  <c:v>Lung</c:v>
                </c:pt>
                <c:pt idx="36">
                  <c:v>Minor_Salivary_Gland</c:v>
                </c:pt>
                <c:pt idx="37">
                  <c:v>Muscle_Skeletal</c:v>
                </c:pt>
                <c:pt idx="38">
                  <c:v>Nerve_Tibial</c:v>
                </c:pt>
                <c:pt idx="39">
                  <c:v>Ovary</c:v>
                </c:pt>
                <c:pt idx="40">
                  <c:v>Pancreas</c:v>
                </c:pt>
                <c:pt idx="41">
                  <c:v>Pituitary</c:v>
                </c:pt>
                <c:pt idx="42">
                  <c:v>Prostate</c:v>
                </c:pt>
                <c:pt idx="43">
                  <c:v>Skin_Not_Sun_Exposed_Suprapubic</c:v>
                </c:pt>
                <c:pt idx="44">
                  <c:v>Skin_Sun_Exposed_Lower_leg</c:v>
                </c:pt>
                <c:pt idx="45">
                  <c:v>Small_Intestine_Terminal_Ileum</c:v>
                </c:pt>
                <c:pt idx="46">
                  <c:v>Spleen</c:v>
                </c:pt>
                <c:pt idx="47">
                  <c:v>Stomach</c:v>
                </c:pt>
                <c:pt idx="48">
                  <c:v>Testis</c:v>
                </c:pt>
                <c:pt idx="49">
                  <c:v>Thyroid</c:v>
                </c:pt>
                <c:pt idx="50">
                  <c:v>Uterus</c:v>
                </c:pt>
                <c:pt idx="51">
                  <c:v>Vagina</c:v>
                </c:pt>
                <c:pt idx="52">
                  <c:v>Whole_Blood</c:v>
                </c:pt>
              </c:strCache>
            </c:strRef>
          </c:cat>
          <c:val>
            <c:numRef>
              <c:f>Consolidated_tissueexp!$I$3:$I$55</c:f>
              <c:numCache>
                <c:formatCode>General</c:formatCode>
                <c:ptCount val="53"/>
                <c:pt idx="0">
                  <c:v>1.302902989351207E-5</c:v>
                </c:pt>
                <c:pt idx="1">
                  <c:v>0</c:v>
                </c:pt>
                <c:pt idx="2">
                  <c:v>2.8158452259282849E-2</c:v>
                </c:pt>
                <c:pt idx="3">
                  <c:v>2.307882058273408E-3</c:v>
                </c:pt>
                <c:pt idx="4">
                  <c:v>6.0805483949666899E-5</c:v>
                </c:pt>
                <c:pt idx="5">
                  <c:v>4.6895509453124696E-3</c:v>
                </c:pt>
                <c:pt idx="6">
                  <c:v>1.5637416252358162E-4</c:v>
                </c:pt>
                <c:pt idx="7">
                  <c:v>6.6316759180200417</c:v>
                </c:pt>
                <c:pt idx="8">
                  <c:v>8.3628606492736601</c:v>
                </c:pt>
                <c:pt idx="9">
                  <c:v>6.7692701554223191</c:v>
                </c:pt>
                <c:pt idx="10">
                  <c:v>9.3594390655953639</c:v>
                </c:pt>
                <c:pt idx="11">
                  <c:v>8.9882604386116824</c:v>
                </c:pt>
                <c:pt idx="12">
                  <c:v>8.8674841650873617</c:v>
                </c:pt>
                <c:pt idx="13">
                  <c:v>9.1524396789445639</c:v>
                </c:pt>
                <c:pt idx="14">
                  <c:v>6.4822236707260439</c:v>
                </c:pt>
                <c:pt idx="15">
                  <c:v>7.2306374460962433</c:v>
                </c:pt>
                <c:pt idx="16">
                  <c:v>6.9819655972954715</c:v>
                </c:pt>
                <c:pt idx="17">
                  <c:v>6.6662102616688026</c:v>
                </c:pt>
                <c:pt idx="18">
                  <c:v>2.5967421742128889</c:v>
                </c:pt>
                <c:pt idx="19">
                  <c:v>4.2586513975241047</c:v>
                </c:pt>
                <c:pt idx="20">
                  <c:v>0</c:v>
                </c:pt>
                <c:pt idx="21">
                  <c:v>0.25767557824759768</c:v>
                </c:pt>
                <c:pt idx="22">
                  <c:v>5.7129178933299343E-2</c:v>
                </c:pt>
                <c:pt idx="23">
                  <c:v>9.9899219688431157E-5</c:v>
                </c:pt>
                <c:pt idx="24">
                  <c:v>1.998214241273805E-4</c:v>
                </c:pt>
                <c:pt idx="25">
                  <c:v>0.25494083080258789</c:v>
                </c:pt>
                <c:pt idx="26">
                  <c:v>2.391609065626598E-2</c:v>
                </c:pt>
                <c:pt idx="27">
                  <c:v>4.682523628010643E-2</c:v>
                </c:pt>
                <c:pt idx="28">
                  <c:v>2.9976662389581986E-4</c:v>
                </c:pt>
                <c:pt idx="29">
                  <c:v>3.9163104376538041E-2</c:v>
                </c:pt>
                <c:pt idx="30">
                  <c:v>1.302902989351207E-5</c:v>
                </c:pt>
                <c:pt idx="31">
                  <c:v>1.4272722870992849E-2</c:v>
                </c:pt>
                <c:pt idx="32">
                  <c:v>5.4309892556872297E-2</c:v>
                </c:pt>
                <c:pt idx="33">
                  <c:v>8.6859764981282404E-6</c:v>
                </c:pt>
                <c:pt idx="34">
                  <c:v>3.314520149792774E-2</c:v>
                </c:pt>
                <c:pt idx="35">
                  <c:v>0</c:v>
                </c:pt>
                <c:pt idx="36">
                  <c:v>7.3836338190138114E-5</c:v>
                </c:pt>
                <c:pt idx="37">
                  <c:v>0.50519167259152575</c:v>
                </c:pt>
                <c:pt idx="38">
                  <c:v>1.5401301074387359E-3</c:v>
                </c:pt>
                <c:pt idx="39">
                  <c:v>8.8192767828833243E-2</c:v>
                </c:pt>
                <c:pt idx="40">
                  <c:v>0.13794618019817945</c:v>
                </c:pt>
                <c:pt idx="41">
                  <c:v>3.2683226123291456</c:v>
                </c:pt>
                <c:pt idx="42">
                  <c:v>7.258780618011368E-4</c:v>
                </c:pt>
                <c:pt idx="43">
                  <c:v>3.9175808305758082E-3</c:v>
                </c:pt>
                <c:pt idx="44">
                  <c:v>1.8976638610393999E-3</c:v>
                </c:pt>
                <c:pt idx="45">
                  <c:v>1.6107715696685315E-2</c:v>
                </c:pt>
                <c:pt idx="46">
                  <c:v>1.099093002192709E-2</c:v>
                </c:pt>
                <c:pt idx="47">
                  <c:v>8.252379157010987E-5</c:v>
                </c:pt>
                <c:pt idx="48">
                  <c:v>0.40201976479937973</c:v>
                </c:pt>
                <c:pt idx="49">
                  <c:v>1.302902989351207E-5</c:v>
                </c:pt>
                <c:pt idx="50">
                  <c:v>2.0929885609056953E-2</c:v>
                </c:pt>
                <c:pt idx="51">
                  <c:v>1.302902989351207E-5</c:v>
                </c:pt>
                <c:pt idx="52">
                  <c:v>0.14622880368758071</c:v>
                </c:pt>
              </c:numCache>
            </c:numRef>
          </c:val>
        </c:ser>
        <c:ser>
          <c:idx val="3"/>
          <c:order val="3"/>
          <c:tx>
            <c:strRef>
              <c:f>Consolidated_tissueexp!$K$1</c:f>
              <c:strCache>
                <c:ptCount val="1"/>
                <c:pt idx="0">
                  <c:v>Edu oulier</c:v>
                </c:pt>
              </c:strCache>
            </c:strRef>
          </c:tx>
          <c:invertIfNegative val="0"/>
          <c:cat>
            <c:strRef>
              <c:f>Consolidated_tissueexp!$A$3:$A$55</c:f>
              <c:strCache>
                <c:ptCount val="53"/>
                <c:pt idx="0">
                  <c:v>Adipose_Subcutaneous</c:v>
                </c:pt>
                <c:pt idx="1">
                  <c:v>Adipose_Visceral_Omentum</c:v>
                </c:pt>
                <c:pt idx="2">
                  <c:v>Adrenal_Gland</c:v>
                </c:pt>
                <c:pt idx="3">
                  <c:v>Artery_Aorta</c:v>
                </c:pt>
                <c:pt idx="4">
                  <c:v>Artery_Coronary</c:v>
                </c:pt>
                <c:pt idx="5">
                  <c:v>Artery_Tibial</c:v>
                </c:pt>
                <c:pt idx="6">
                  <c:v>Bladder</c:v>
                </c:pt>
                <c:pt idx="7">
                  <c:v>Brain_Amygdala</c:v>
                </c:pt>
                <c:pt idx="8">
                  <c:v>Brain_Anterior_cingulate_cortex_BA24</c:v>
                </c:pt>
                <c:pt idx="9">
                  <c:v>Brain_Caudate_basal_ganglia</c:v>
                </c:pt>
                <c:pt idx="10">
                  <c:v>Brain_Cerebellar_Hemisphere</c:v>
                </c:pt>
                <c:pt idx="11">
                  <c:v>Brain_Cerebellum</c:v>
                </c:pt>
                <c:pt idx="12">
                  <c:v>Brain_Cortex</c:v>
                </c:pt>
                <c:pt idx="13">
                  <c:v>Brain_Frontal_Cortex_BA9</c:v>
                </c:pt>
                <c:pt idx="14">
                  <c:v>Brain_Hippocampus</c:v>
                </c:pt>
                <c:pt idx="15">
                  <c:v>Brain_Hypothalamus</c:v>
                </c:pt>
                <c:pt idx="16">
                  <c:v>Brain_Nucleus_accumbens_basal_ganglia</c:v>
                </c:pt>
                <c:pt idx="17">
                  <c:v>Brain_Putamen_basal_ganglia</c:v>
                </c:pt>
                <c:pt idx="18">
                  <c:v>Brain_Spinal_cord_cervical_c.1</c:v>
                </c:pt>
                <c:pt idx="19">
                  <c:v>Brain_Substantia_nigra</c:v>
                </c:pt>
                <c:pt idx="20">
                  <c:v>Breast_Mammary_Tissue</c:v>
                </c:pt>
                <c:pt idx="21">
                  <c:v>Cells_EBV.transformed_lymphocytes</c:v>
                </c:pt>
                <c:pt idx="22">
                  <c:v>Cells_Transformed_fibroblasts</c:v>
                </c:pt>
                <c:pt idx="23">
                  <c:v>Cervix_Ectocervix</c:v>
                </c:pt>
                <c:pt idx="24">
                  <c:v>Cervix_Endocervix</c:v>
                </c:pt>
                <c:pt idx="25">
                  <c:v>Colon_Sigmoid</c:v>
                </c:pt>
                <c:pt idx="26">
                  <c:v>Colon_Transverse</c:v>
                </c:pt>
                <c:pt idx="27">
                  <c:v>Esophagus_Gastroesophageal_Junction</c:v>
                </c:pt>
                <c:pt idx="28">
                  <c:v>Esophagus_Mucosa</c:v>
                </c:pt>
                <c:pt idx="29">
                  <c:v>Esophagus_Muscularis</c:v>
                </c:pt>
                <c:pt idx="30">
                  <c:v>Fallopian_Tube</c:v>
                </c:pt>
                <c:pt idx="31">
                  <c:v>Heart_Atrial_Appendage</c:v>
                </c:pt>
                <c:pt idx="32">
                  <c:v>Heart_Left_Ventricle</c:v>
                </c:pt>
                <c:pt idx="33">
                  <c:v>Kidney_Cortex</c:v>
                </c:pt>
                <c:pt idx="34">
                  <c:v>Liver</c:v>
                </c:pt>
                <c:pt idx="35">
                  <c:v>Lung</c:v>
                </c:pt>
                <c:pt idx="36">
                  <c:v>Minor_Salivary_Gland</c:v>
                </c:pt>
                <c:pt idx="37">
                  <c:v>Muscle_Skeletal</c:v>
                </c:pt>
                <c:pt idx="38">
                  <c:v>Nerve_Tibial</c:v>
                </c:pt>
                <c:pt idx="39">
                  <c:v>Ovary</c:v>
                </c:pt>
                <c:pt idx="40">
                  <c:v>Pancreas</c:v>
                </c:pt>
                <c:pt idx="41">
                  <c:v>Pituitary</c:v>
                </c:pt>
                <c:pt idx="42">
                  <c:v>Prostate</c:v>
                </c:pt>
                <c:pt idx="43">
                  <c:v>Skin_Not_Sun_Exposed_Suprapubic</c:v>
                </c:pt>
                <c:pt idx="44">
                  <c:v>Skin_Sun_Exposed_Lower_leg</c:v>
                </c:pt>
                <c:pt idx="45">
                  <c:v>Small_Intestine_Terminal_Ileum</c:v>
                </c:pt>
                <c:pt idx="46">
                  <c:v>Spleen</c:v>
                </c:pt>
                <c:pt idx="47">
                  <c:v>Stomach</c:v>
                </c:pt>
                <c:pt idx="48">
                  <c:v>Testis</c:v>
                </c:pt>
                <c:pt idx="49">
                  <c:v>Thyroid</c:v>
                </c:pt>
                <c:pt idx="50">
                  <c:v>Uterus</c:v>
                </c:pt>
                <c:pt idx="51">
                  <c:v>Vagina</c:v>
                </c:pt>
                <c:pt idx="52">
                  <c:v>Whole_Blood</c:v>
                </c:pt>
              </c:strCache>
            </c:strRef>
          </c:cat>
          <c:val>
            <c:numRef>
              <c:f>Consolidated_tissueexp!$K$3:$K$55</c:f>
              <c:numCache>
                <c:formatCode>General</c:formatCode>
                <c:ptCount val="53"/>
                <c:pt idx="0">
                  <c:v>9.5368251194023583E-3</c:v>
                </c:pt>
                <c:pt idx="1">
                  <c:v>2.7117083623571705E-2</c:v>
                </c:pt>
                <c:pt idx="2">
                  <c:v>0.25553489822107667</c:v>
                </c:pt>
                <c:pt idx="3">
                  <c:v>8.7071527284570946E-2</c:v>
                </c:pt>
                <c:pt idx="4">
                  <c:v>2.3943624409711123E-2</c:v>
                </c:pt>
                <c:pt idx="5">
                  <c:v>0.20386990105093847</c:v>
                </c:pt>
                <c:pt idx="6">
                  <c:v>1.300446027561836E-2</c:v>
                </c:pt>
                <c:pt idx="7">
                  <c:v>2.7493116963542787</c:v>
                </c:pt>
                <c:pt idx="8">
                  <c:v>3.8041556752527179</c:v>
                </c:pt>
                <c:pt idx="9">
                  <c:v>2.3454961754329529</c:v>
                </c:pt>
                <c:pt idx="10">
                  <c:v>3.9922095625540215</c:v>
                </c:pt>
                <c:pt idx="11">
                  <c:v>3.6409997726253134</c:v>
                </c:pt>
                <c:pt idx="12">
                  <c:v>4.2173697397823906</c:v>
                </c:pt>
                <c:pt idx="13">
                  <c:v>4.470775034372668</c:v>
                </c:pt>
                <c:pt idx="14">
                  <c:v>3.1088920315850528</c:v>
                </c:pt>
                <c:pt idx="15">
                  <c:v>1.8505653336568311</c:v>
                </c:pt>
                <c:pt idx="16">
                  <c:v>2.5543179731473207</c:v>
                </c:pt>
                <c:pt idx="17">
                  <c:v>2.6611651577089033</c:v>
                </c:pt>
                <c:pt idx="18">
                  <c:v>0.98088370955292725</c:v>
                </c:pt>
                <c:pt idx="19">
                  <c:v>0.90703386240563544</c:v>
                </c:pt>
                <c:pt idx="20">
                  <c:v>7.9548699468698792E-4</c:v>
                </c:pt>
                <c:pt idx="21">
                  <c:v>0.91796901873298797</c:v>
                </c:pt>
                <c:pt idx="22">
                  <c:v>0.15681084046785654</c:v>
                </c:pt>
                <c:pt idx="23">
                  <c:v>9.7277599041317823E-3</c:v>
                </c:pt>
                <c:pt idx="24">
                  <c:v>1.9412856814944395E-3</c:v>
                </c:pt>
                <c:pt idx="25">
                  <c:v>4.6182341793003324E-2</c:v>
                </c:pt>
                <c:pt idx="26">
                  <c:v>2.8539858974305672E-3</c:v>
                </c:pt>
                <c:pt idx="27">
                  <c:v>6.8603158584613882E-2</c:v>
                </c:pt>
                <c:pt idx="28">
                  <c:v>4.3087565090845825E-2</c:v>
                </c:pt>
                <c:pt idx="29">
                  <c:v>7.801716116222393E-2</c:v>
                </c:pt>
                <c:pt idx="30">
                  <c:v>7.7373300463524409E-4</c:v>
                </c:pt>
                <c:pt idx="31">
                  <c:v>2.9904287411177909E-2</c:v>
                </c:pt>
                <c:pt idx="32">
                  <c:v>9.7600003322912299E-2</c:v>
                </c:pt>
                <c:pt idx="33">
                  <c:v>1.4627423095618814E-2</c:v>
                </c:pt>
                <c:pt idx="34">
                  <c:v>0.1021146078085461</c:v>
                </c:pt>
                <c:pt idx="35">
                  <c:v>1.5183387868471403E-3</c:v>
                </c:pt>
                <c:pt idx="36">
                  <c:v>1.1916001191059416E-3</c:v>
                </c:pt>
                <c:pt idx="37">
                  <c:v>0.621456752838356</c:v>
                </c:pt>
                <c:pt idx="38">
                  <c:v>2.2276394711152253E-2</c:v>
                </c:pt>
                <c:pt idx="39">
                  <c:v>0.11102343956139162</c:v>
                </c:pt>
                <c:pt idx="40">
                  <c:v>0.16950756675091147</c:v>
                </c:pt>
                <c:pt idx="41">
                  <c:v>1.3112065607144623</c:v>
                </c:pt>
                <c:pt idx="42">
                  <c:v>8.4334960877227268E-4</c:v>
                </c:pt>
                <c:pt idx="43">
                  <c:v>0.11101783160088018</c:v>
                </c:pt>
                <c:pt idx="44">
                  <c:v>8.4151853961124248E-2</c:v>
                </c:pt>
                <c:pt idx="45">
                  <c:v>2.6728945236014812E-2</c:v>
                </c:pt>
                <c:pt idx="46">
                  <c:v>0.16654688526891601</c:v>
                </c:pt>
                <c:pt idx="47">
                  <c:v>2.2154668497858181E-4</c:v>
                </c:pt>
                <c:pt idx="48">
                  <c:v>0.44912374715714548</c:v>
                </c:pt>
                <c:pt idx="49">
                  <c:v>3.6061409554019721E-4</c:v>
                </c:pt>
                <c:pt idx="50">
                  <c:v>1.2378417874516247E-2</c:v>
                </c:pt>
                <c:pt idx="51">
                  <c:v>5.7752602431288954E-3</c:v>
                </c:pt>
                <c:pt idx="52">
                  <c:v>0.17389927004434344</c:v>
                </c:pt>
              </c:numCache>
            </c:numRef>
          </c:val>
        </c:ser>
        <c:ser>
          <c:idx val="4"/>
          <c:order val="4"/>
          <c:tx>
            <c:strRef>
              <c:f>Consolidated_tissueexp!$L$1</c:f>
              <c:strCache>
                <c:ptCount val="1"/>
                <c:pt idx="0">
                  <c:v>Cog outlier</c:v>
                </c:pt>
              </c:strCache>
            </c:strRef>
          </c:tx>
          <c:invertIfNegative val="0"/>
          <c:cat>
            <c:strRef>
              <c:f>Consolidated_tissueexp!$A$3:$A$55</c:f>
              <c:strCache>
                <c:ptCount val="53"/>
                <c:pt idx="0">
                  <c:v>Adipose_Subcutaneous</c:v>
                </c:pt>
                <c:pt idx="1">
                  <c:v>Adipose_Visceral_Omentum</c:v>
                </c:pt>
                <c:pt idx="2">
                  <c:v>Adrenal_Gland</c:v>
                </c:pt>
                <c:pt idx="3">
                  <c:v>Artery_Aorta</c:v>
                </c:pt>
                <c:pt idx="4">
                  <c:v>Artery_Coronary</c:v>
                </c:pt>
                <c:pt idx="5">
                  <c:v>Artery_Tibial</c:v>
                </c:pt>
                <c:pt idx="6">
                  <c:v>Bladder</c:v>
                </c:pt>
                <c:pt idx="7">
                  <c:v>Brain_Amygdala</c:v>
                </c:pt>
                <c:pt idx="8">
                  <c:v>Brain_Anterior_cingulate_cortex_BA24</c:v>
                </c:pt>
                <c:pt idx="9">
                  <c:v>Brain_Caudate_basal_ganglia</c:v>
                </c:pt>
                <c:pt idx="10">
                  <c:v>Brain_Cerebellar_Hemisphere</c:v>
                </c:pt>
                <c:pt idx="11">
                  <c:v>Brain_Cerebellum</c:v>
                </c:pt>
                <c:pt idx="12">
                  <c:v>Brain_Cortex</c:v>
                </c:pt>
                <c:pt idx="13">
                  <c:v>Brain_Frontal_Cortex_BA9</c:v>
                </c:pt>
                <c:pt idx="14">
                  <c:v>Brain_Hippocampus</c:v>
                </c:pt>
                <c:pt idx="15">
                  <c:v>Brain_Hypothalamus</c:v>
                </c:pt>
                <c:pt idx="16">
                  <c:v>Brain_Nucleus_accumbens_basal_ganglia</c:v>
                </c:pt>
                <c:pt idx="17">
                  <c:v>Brain_Putamen_basal_ganglia</c:v>
                </c:pt>
                <c:pt idx="18">
                  <c:v>Brain_Spinal_cord_cervical_c.1</c:v>
                </c:pt>
                <c:pt idx="19">
                  <c:v>Brain_Substantia_nigra</c:v>
                </c:pt>
                <c:pt idx="20">
                  <c:v>Breast_Mammary_Tissue</c:v>
                </c:pt>
                <c:pt idx="21">
                  <c:v>Cells_EBV.transformed_lymphocytes</c:v>
                </c:pt>
                <c:pt idx="22">
                  <c:v>Cells_Transformed_fibroblasts</c:v>
                </c:pt>
                <c:pt idx="23">
                  <c:v>Cervix_Ectocervix</c:v>
                </c:pt>
                <c:pt idx="24">
                  <c:v>Cervix_Endocervix</c:v>
                </c:pt>
                <c:pt idx="25">
                  <c:v>Colon_Sigmoid</c:v>
                </c:pt>
                <c:pt idx="26">
                  <c:v>Colon_Transverse</c:v>
                </c:pt>
                <c:pt idx="27">
                  <c:v>Esophagus_Gastroesophageal_Junction</c:v>
                </c:pt>
                <c:pt idx="28">
                  <c:v>Esophagus_Mucosa</c:v>
                </c:pt>
                <c:pt idx="29">
                  <c:v>Esophagus_Muscularis</c:v>
                </c:pt>
                <c:pt idx="30">
                  <c:v>Fallopian_Tube</c:v>
                </c:pt>
                <c:pt idx="31">
                  <c:v>Heart_Atrial_Appendage</c:v>
                </c:pt>
                <c:pt idx="32">
                  <c:v>Heart_Left_Ventricle</c:v>
                </c:pt>
                <c:pt idx="33">
                  <c:v>Kidney_Cortex</c:v>
                </c:pt>
                <c:pt idx="34">
                  <c:v>Liver</c:v>
                </c:pt>
                <c:pt idx="35">
                  <c:v>Lung</c:v>
                </c:pt>
                <c:pt idx="36">
                  <c:v>Minor_Salivary_Gland</c:v>
                </c:pt>
                <c:pt idx="37">
                  <c:v>Muscle_Skeletal</c:v>
                </c:pt>
                <c:pt idx="38">
                  <c:v>Nerve_Tibial</c:v>
                </c:pt>
                <c:pt idx="39">
                  <c:v>Ovary</c:v>
                </c:pt>
                <c:pt idx="40">
                  <c:v>Pancreas</c:v>
                </c:pt>
                <c:pt idx="41">
                  <c:v>Pituitary</c:v>
                </c:pt>
                <c:pt idx="42">
                  <c:v>Prostate</c:v>
                </c:pt>
                <c:pt idx="43">
                  <c:v>Skin_Not_Sun_Exposed_Suprapubic</c:v>
                </c:pt>
                <c:pt idx="44">
                  <c:v>Skin_Sun_Exposed_Lower_leg</c:v>
                </c:pt>
                <c:pt idx="45">
                  <c:v>Small_Intestine_Terminal_Ileum</c:v>
                </c:pt>
                <c:pt idx="46">
                  <c:v>Spleen</c:v>
                </c:pt>
                <c:pt idx="47">
                  <c:v>Stomach</c:v>
                </c:pt>
                <c:pt idx="48">
                  <c:v>Testis</c:v>
                </c:pt>
                <c:pt idx="49">
                  <c:v>Thyroid</c:v>
                </c:pt>
                <c:pt idx="50">
                  <c:v>Uterus</c:v>
                </c:pt>
                <c:pt idx="51">
                  <c:v>Vagina</c:v>
                </c:pt>
                <c:pt idx="52">
                  <c:v>Whole_Blood</c:v>
                </c:pt>
              </c:strCache>
            </c:strRef>
          </c:cat>
          <c:val>
            <c:numRef>
              <c:f>Consolidated_tissueexp!$L$3:$L$55</c:f>
              <c:numCache>
                <c:formatCode>General</c:formatCode>
                <c:ptCount val="53"/>
                <c:pt idx="0">
                  <c:v>0.16771467876513296</c:v>
                </c:pt>
                <c:pt idx="1">
                  <c:v>0.35033419090797441</c:v>
                </c:pt>
                <c:pt idx="2">
                  <c:v>0.10829532376081731</c:v>
                </c:pt>
                <c:pt idx="3">
                  <c:v>4.5825052735054335E-2</c:v>
                </c:pt>
                <c:pt idx="4">
                  <c:v>5.1283916402494849E-2</c:v>
                </c:pt>
                <c:pt idx="5">
                  <c:v>0.23223580550971637</c:v>
                </c:pt>
                <c:pt idx="6">
                  <c:v>0.13373038758296008</c:v>
                </c:pt>
                <c:pt idx="7">
                  <c:v>0.34731861523642582</c:v>
                </c:pt>
                <c:pt idx="8">
                  <c:v>0.37428637218879862</c:v>
                </c:pt>
                <c:pt idx="9">
                  <c:v>0.31927479377584544</c:v>
                </c:pt>
                <c:pt idx="10">
                  <c:v>1.1254775959277268</c:v>
                </c:pt>
                <c:pt idx="11">
                  <c:v>1.1563499514003528</c:v>
                </c:pt>
                <c:pt idx="12">
                  <c:v>0.5044695378982692</c:v>
                </c:pt>
                <c:pt idx="13">
                  <c:v>0.47023609595988225</c:v>
                </c:pt>
                <c:pt idx="14">
                  <c:v>0.44557141527794514</c:v>
                </c:pt>
                <c:pt idx="15">
                  <c:v>0.4959643296075355</c:v>
                </c:pt>
                <c:pt idx="16">
                  <c:v>0.49031370382877126</c:v>
                </c:pt>
                <c:pt idx="17">
                  <c:v>0.27848615791597758</c:v>
                </c:pt>
                <c:pt idx="18">
                  <c:v>0.24808224451919772</c:v>
                </c:pt>
                <c:pt idx="19">
                  <c:v>0.22082213369274534</c:v>
                </c:pt>
                <c:pt idx="20">
                  <c:v>8.9898770786248819E-2</c:v>
                </c:pt>
                <c:pt idx="21">
                  <c:v>2.3278559429810088</c:v>
                </c:pt>
                <c:pt idx="22">
                  <c:v>0.80938820218639507</c:v>
                </c:pt>
                <c:pt idx="23">
                  <c:v>0.28435593306204415</c:v>
                </c:pt>
                <c:pt idx="24">
                  <c:v>7.2881251556320428E-2</c:v>
                </c:pt>
                <c:pt idx="25">
                  <c:v>0.17376965698285576</c:v>
                </c:pt>
                <c:pt idx="26">
                  <c:v>8.2830713027291475E-2</c:v>
                </c:pt>
                <c:pt idx="27">
                  <c:v>2.8320667596255324E-2</c:v>
                </c:pt>
                <c:pt idx="28">
                  <c:v>0.23763658285492253</c:v>
                </c:pt>
                <c:pt idx="29">
                  <c:v>2.2994717211356895E-2</c:v>
                </c:pt>
                <c:pt idx="30">
                  <c:v>0.10342969393805991</c:v>
                </c:pt>
                <c:pt idx="31">
                  <c:v>6.2978871818751711E-2</c:v>
                </c:pt>
                <c:pt idx="32">
                  <c:v>8.3540787306440517E-2</c:v>
                </c:pt>
                <c:pt idx="33">
                  <c:v>0.19911116198355763</c:v>
                </c:pt>
                <c:pt idx="34">
                  <c:v>8.2601654527883258E-3</c:v>
                </c:pt>
                <c:pt idx="35">
                  <c:v>0.32938311359967448</c:v>
                </c:pt>
                <c:pt idx="36">
                  <c:v>0.13871656079367548</c:v>
                </c:pt>
                <c:pt idx="37">
                  <c:v>0.3922984104189397</c:v>
                </c:pt>
                <c:pt idx="38">
                  <c:v>0.14020145251943436</c:v>
                </c:pt>
                <c:pt idx="39">
                  <c:v>0.19960601403185962</c:v>
                </c:pt>
                <c:pt idx="40">
                  <c:v>0.352294363341144</c:v>
                </c:pt>
                <c:pt idx="41">
                  <c:v>0.81171852047733295</c:v>
                </c:pt>
                <c:pt idx="42">
                  <c:v>0.11780002346872621</c:v>
                </c:pt>
                <c:pt idx="43">
                  <c:v>0.35866472727359155</c:v>
                </c:pt>
                <c:pt idx="44">
                  <c:v>0.2864422598640074</c:v>
                </c:pt>
                <c:pt idx="45">
                  <c:v>7.8542434620211446E-2</c:v>
                </c:pt>
                <c:pt idx="46">
                  <c:v>1.3595185630295781</c:v>
                </c:pt>
                <c:pt idx="47">
                  <c:v>0.19064906622212099</c:v>
                </c:pt>
                <c:pt idx="48">
                  <c:v>1.3242124960917208</c:v>
                </c:pt>
                <c:pt idx="49">
                  <c:v>0.15042090330665023</c:v>
                </c:pt>
                <c:pt idx="50">
                  <c:v>0.1144861251469772</c:v>
                </c:pt>
                <c:pt idx="51">
                  <c:v>0.23611548847089872</c:v>
                </c:pt>
                <c:pt idx="52">
                  <c:v>0.61984304849184035</c:v>
                </c:pt>
              </c:numCache>
            </c:numRef>
          </c:val>
        </c:ser>
        <c:ser>
          <c:idx val="5"/>
          <c:order val="5"/>
          <c:tx>
            <c:strRef>
              <c:f>Consolidated_tissueexp!$M$1</c:f>
              <c:strCache>
                <c:ptCount val="1"/>
                <c:pt idx="0">
                  <c:v>Discordant</c:v>
                </c:pt>
              </c:strCache>
            </c:strRef>
          </c:tx>
          <c:invertIfNegative val="0"/>
          <c:val>
            <c:numRef>
              <c:f>Consolidated_tissueexp!$M$3:$M$55</c:f>
              <c:numCache>
                <c:formatCode>General</c:formatCode>
                <c:ptCount val="53"/>
                <c:pt idx="0">
                  <c:v>8.6859764981282404E-6</c:v>
                </c:pt>
                <c:pt idx="1">
                  <c:v>4.3429665338816141E-6</c:v>
                </c:pt>
                <c:pt idx="2">
                  <c:v>0.13367130150604065</c:v>
                </c:pt>
                <c:pt idx="3">
                  <c:v>1.9761862928163324E-3</c:v>
                </c:pt>
                <c:pt idx="4">
                  <c:v>8.252379157010987E-5</c:v>
                </c:pt>
                <c:pt idx="5">
                  <c:v>5.3002031829528151E-3</c:v>
                </c:pt>
                <c:pt idx="6">
                  <c:v>2.1285645022284041E-4</c:v>
                </c:pt>
                <c:pt idx="7">
                  <c:v>9.2060071779319905</c:v>
                </c:pt>
                <c:pt idx="8">
                  <c:v>11.682354456778841</c:v>
                </c:pt>
                <c:pt idx="9">
                  <c:v>8.7004927012995132</c:v>
                </c:pt>
                <c:pt idx="10">
                  <c:v>12.545109427188763</c:v>
                </c:pt>
                <c:pt idx="11">
                  <c:v>12.248921148853828</c:v>
                </c:pt>
                <c:pt idx="12">
                  <c:v>12.630914079178492</c:v>
                </c:pt>
                <c:pt idx="13">
                  <c:v>12.560114919182698</c:v>
                </c:pt>
                <c:pt idx="14">
                  <c:v>10.265792430268544</c:v>
                </c:pt>
                <c:pt idx="15">
                  <c:v>7.2306743787256256</c:v>
                </c:pt>
                <c:pt idx="16">
                  <c:v>10.27471740715931</c:v>
                </c:pt>
                <c:pt idx="17">
                  <c:v>9.4456319990099118</c:v>
                </c:pt>
                <c:pt idx="18">
                  <c:v>3.8390515191353032</c:v>
                </c:pt>
                <c:pt idx="19">
                  <c:v>4.5106322252952662</c:v>
                </c:pt>
                <c:pt idx="20">
                  <c:v>0</c:v>
                </c:pt>
                <c:pt idx="21">
                  <c:v>8.2746632976323981E-2</c:v>
                </c:pt>
                <c:pt idx="22">
                  <c:v>2.6165837488117443E-2</c:v>
                </c:pt>
                <c:pt idx="23">
                  <c:v>6.0843828090904916E-4</c:v>
                </c:pt>
                <c:pt idx="24">
                  <c:v>1.1727534299772331E-4</c:v>
                </c:pt>
                <c:pt idx="25">
                  <c:v>6.8372185956822804E-3</c:v>
                </c:pt>
                <c:pt idx="26">
                  <c:v>3.041125891607762E-4</c:v>
                </c:pt>
                <c:pt idx="27">
                  <c:v>1.4398990849054619E-3</c:v>
                </c:pt>
                <c:pt idx="28">
                  <c:v>8.4770101708048131E-4</c:v>
                </c:pt>
                <c:pt idx="29">
                  <c:v>1.8976638610393999E-3</c:v>
                </c:pt>
                <c:pt idx="30">
                  <c:v>8.6859764981282404E-6</c:v>
                </c:pt>
                <c:pt idx="31">
                  <c:v>7.769119755951898E-3</c:v>
                </c:pt>
                <c:pt idx="32">
                  <c:v>1.9401302843342561E-2</c:v>
                </c:pt>
                <c:pt idx="33">
                  <c:v>1.3266222987905929E-3</c:v>
                </c:pt>
                <c:pt idx="34">
                  <c:v>2.2157551430759585E-2</c:v>
                </c:pt>
                <c:pt idx="35">
                  <c:v>0</c:v>
                </c:pt>
                <c:pt idx="36">
                  <c:v>0</c:v>
                </c:pt>
                <c:pt idx="37">
                  <c:v>0.19008356976982263</c:v>
                </c:pt>
                <c:pt idx="38">
                  <c:v>3.9482579989949815E-3</c:v>
                </c:pt>
                <c:pt idx="39">
                  <c:v>1.6793327642295734E-2</c:v>
                </c:pt>
                <c:pt idx="40">
                  <c:v>5.1287824260782449E-3</c:v>
                </c:pt>
                <c:pt idx="41">
                  <c:v>3.0762794518233672</c:v>
                </c:pt>
                <c:pt idx="42">
                  <c:v>2.3458236316769576E-4</c:v>
                </c:pt>
                <c:pt idx="43">
                  <c:v>2.3209805110077654E-3</c:v>
                </c:pt>
                <c:pt idx="44">
                  <c:v>1.1785356840623789E-3</c:v>
                </c:pt>
                <c:pt idx="45">
                  <c:v>7.9983792346033616E-4</c:v>
                </c:pt>
                <c:pt idx="46">
                  <c:v>2.4315501033689665E-2</c:v>
                </c:pt>
                <c:pt idx="47">
                  <c:v>0</c:v>
                </c:pt>
                <c:pt idx="48">
                  <c:v>0.98999702587294036</c:v>
                </c:pt>
                <c:pt idx="49">
                  <c:v>5.6461952753858298E-5</c:v>
                </c:pt>
                <c:pt idx="50">
                  <c:v>1.832239344577682E-3</c:v>
                </c:pt>
                <c:pt idx="51">
                  <c:v>1.085871944407351E-4</c:v>
                </c:pt>
                <c:pt idx="52">
                  <c:v>5.318433738709918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228681600"/>
        <c:axId val="228683136"/>
      </c:barChart>
      <c:catAx>
        <c:axId val="228681600"/>
        <c:scaling>
          <c:orientation val="minMax"/>
        </c:scaling>
        <c:delete val="0"/>
        <c:axPos val="l"/>
        <c:numFmt formatCode="General" sourceLinked="0"/>
        <c:majorTickMark val="none"/>
        <c:minorTickMark val="none"/>
        <c:tickLblPos val="low"/>
        <c:txPr>
          <a:bodyPr/>
          <a:lstStyle/>
          <a:p>
            <a:pPr>
              <a:defRPr sz="1050"/>
            </a:pPr>
            <a:endParaRPr lang="en-US"/>
          </a:p>
        </c:txPr>
        <c:crossAx val="228683136"/>
        <c:crosses val="autoZero"/>
        <c:auto val="1"/>
        <c:lblAlgn val="ctr"/>
        <c:lblOffset val="100"/>
        <c:noMultiLvlLbl val="0"/>
      </c:catAx>
      <c:valAx>
        <c:axId val="228683136"/>
        <c:scaling>
          <c:orientation val="minMax"/>
        </c:scaling>
        <c:delete val="0"/>
        <c:axPos val="b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SG"/>
                  <a:t>-log10p</a:t>
                </a:r>
              </a:p>
              <a:p>
                <a:pPr>
                  <a:defRPr/>
                </a:pPr>
                <a:endParaRPr lang="en-SG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2868160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3833347914844005"/>
          <c:y val="2.1683274804613399E-2"/>
          <c:w val="0.21351837270341201"/>
          <c:h val="0.14092691655648201"/>
        </c:manualLayout>
      </c:layout>
      <c:overlay val="0"/>
      <c:spPr>
        <a:solidFill>
          <a:schemeClr val="bg1">
            <a:lumMod val="95000"/>
          </a:schemeClr>
        </a:solidFill>
      </c:spPr>
    </c:legend>
    <c:plotVisOnly val="1"/>
    <c:dispBlanksAs val="gap"/>
    <c:showDLblsOverMax val="0"/>
  </c:chart>
  <c:spPr>
    <a:ln>
      <a:noFill/>
    </a:ln>
    <a:scene3d>
      <a:camera prst="orthographicFront"/>
      <a:lightRig rig="threePt" dir="t"/>
    </a:scene3d>
    <a:sp3d/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250B0D-59D2-AE40-8C2D-ECC24E3F548A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63A7DD-5CCF-EF47-AD9B-EEAE4CC53F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4422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8039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779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97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882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854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525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203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652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643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980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19594C-E1CD-4B48-BCB6-07E3AB42CF0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2E619-1237-4220-9FA1-8C1368CDC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2875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307829"/>
          </a:xfrm>
        </p:spPr>
        <p:txBody>
          <a:bodyPr>
            <a:normAutofit/>
          </a:bodyPr>
          <a:lstStyle/>
          <a:p>
            <a:r>
              <a:rPr lang="en-US" sz="1200" dirty="0" smtClean="0"/>
              <a:t>Supplementary Figures</a:t>
            </a:r>
            <a:endParaRPr lang="en-US" sz="1200" dirty="0"/>
          </a:p>
        </p:txBody>
      </p:sp>
      <p:sp>
        <p:nvSpPr>
          <p:cNvPr id="5" name="Content Placeholder 4"/>
          <p:cNvSpPr>
            <a:spLocks noGrp="1"/>
          </p:cNvSpPr>
          <p:nvPr>
            <p:ph sz="half" idx="1"/>
          </p:nvPr>
        </p:nvSpPr>
        <p:spPr>
          <a:xfrm>
            <a:off x="342900" y="704528"/>
            <a:ext cx="6254452" cy="814437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200" dirty="0" smtClean="0"/>
              <a:t>Supplementary Figure </a:t>
            </a:r>
            <a:r>
              <a:rPr lang="en-US" sz="1200" dirty="0"/>
              <a:t>1: </a:t>
            </a:r>
            <a:r>
              <a:rPr lang="en-US" sz="1200" dirty="0" smtClean="0"/>
              <a:t>Preliminary Analysis and ASSET Meta Analysis Workflow</a:t>
            </a:r>
            <a:endParaRPr lang="en-US" sz="1200" dirty="0"/>
          </a:p>
          <a:p>
            <a:pPr marL="0" indent="0">
              <a:buNone/>
            </a:pPr>
            <a:r>
              <a:rPr lang="en-US" sz="1200" dirty="0" smtClean="0"/>
              <a:t>Supplementary Figure </a:t>
            </a:r>
            <a:r>
              <a:rPr lang="en-US" sz="1200" dirty="0"/>
              <a:t>2</a:t>
            </a:r>
            <a:r>
              <a:rPr lang="en-US" sz="1200" dirty="0" smtClean="0"/>
              <a:t>: GWAS Loci Functional Characterization Workflow</a:t>
            </a:r>
            <a:endParaRPr lang="en-US" sz="1200" dirty="0"/>
          </a:p>
          <a:p>
            <a:pPr marL="0" indent="0">
              <a:buNone/>
            </a:pPr>
            <a:r>
              <a:rPr lang="en-US" sz="1200" smtClean="0"/>
              <a:t>Supplementary Figure </a:t>
            </a:r>
            <a:r>
              <a:rPr lang="en-US" sz="1200" dirty="0" smtClean="0"/>
              <a:t>3: </a:t>
            </a:r>
            <a:r>
              <a:rPr lang="en-US" sz="1200" dirty="0"/>
              <a:t>MAGMA </a:t>
            </a:r>
            <a:r>
              <a:rPr lang="en-US" sz="1200" dirty="0" smtClean="0"/>
              <a:t>Gene property tissue expression results for </a:t>
            </a:r>
            <a:r>
              <a:rPr lang="en-US" sz="1200" smtClean="0"/>
              <a:t>ASSET Subsets</a:t>
            </a:r>
            <a:endParaRPr lang="en-US" sz="1200" dirty="0" smtClean="0"/>
          </a:p>
        </p:txBody>
      </p:sp>
    </p:spTree>
    <p:extLst>
      <p:ext uri="{BB962C8B-B14F-4D97-AF65-F5344CB8AC3E}">
        <p14:creationId xmlns:p14="http://schemas.microsoft.com/office/powerpoint/2010/main" val="29351857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13755" y="627783"/>
            <a:ext cx="3028207" cy="866899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Meta-Analysis of </a:t>
            </a:r>
            <a:br>
              <a:rPr lang="en-US" sz="1200" dirty="0"/>
            </a:br>
            <a:r>
              <a:rPr lang="en-US" sz="1200" dirty="0"/>
              <a:t>Cognitive Phenotypes </a:t>
            </a:r>
          </a:p>
          <a:p>
            <a:pPr algn="ctr"/>
            <a:r>
              <a:rPr lang="en-US" sz="1200" dirty="0" err="1"/>
              <a:t>Trampush</a:t>
            </a:r>
            <a:r>
              <a:rPr lang="en-US" sz="1200" dirty="0"/>
              <a:t> et al., 2017 + </a:t>
            </a:r>
            <a:r>
              <a:rPr lang="en-US" sz="1200" dirty="0" err="1"/>
              <a:t>Sniekers</a:t>
            </a:r>
            <a:r>
              <a:rPr lang="en-US" sz="1200" dirty="0"/>
              <a:t> et al., 2017</a:t>
            </a:r>
          </a:p>
          <a:p>
            <a:pPr algn="ctr"/>
            <a:r>
              <a:rPr lang="en-US" sz="1200" dirty="0"/>
              <a:t>N = 107,207</a:t>
            </a:r>
            <a:endParaRPr lang="en-SG" sz="1200" dirty="0"/>
          </a:p>
        </p:txBody>
      </p:sp>
      <p:sp>
        <p:nvSpPr>
          <p:cNvPr id="6" name="Rectangle 5"/>
          <p:cNvSpPr/>
          <p:nvPr/>
        </p:nvSpPr>
        <p:spPr>
          <a:xfrm>
            <a:off x="3621974" y="627784"/>
            <a:ext cx="3133107" cy="866899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Summary Statistics of Education GWAS </a:t>
            </a:r>
          </a:p>
          <a:p>
            <a:pPr algn="ctr"/>
            <a:r>
              <a:rPr lang="en-US" sz="1200" dirty="0" err="1"/>
              <a:t>Okbay</a:t>
            </a:r>
            <a:r>
              <a:rPr lang="en-US" sz="1200" dirty="0"/>
              <a:t> et al., 2016</a:t>
            </a:r>
          </a:p>
          <a:p>
            <a:pPr algn="ctr"/>
            <a:r>
              <a:rPr lang="en-US" sz="1200" dirty="0"/>
              <a:t>N = 328,917</a:t>
            </a:r>
            <a:endParaRPr lang="en-SG" sz="1200" dirty="0"/>
          </a:p>
        </p:txBody>
      </p:sp>
      <p:cxnSp>
        <p:nvCxnSpPr>
          <p:cNvPr id="8" name="Straight Connector 7"/>
          <p:cNvCxnSpPr>
            <a:stCxn id="5" idx="3"/>
            <a:endCxn id="6" idx="1"/>
          </p:cNvCxnSpPr>
          <p:nvPr/>
        </p:nvCxnSpPr>
        <p:spPr>
          <a:xfrm>
            <a:off x="3241962" y="1061233"/>
            <a:ext cx="380012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>
            <a:endCxn id="17" idx="0"/>
          </p:cNvCxnSpPr>
          <p:nvPr/>
        </p:nvCxnSpPr>
        <p:spPr>
          <a:xfrm>
            <a:off x="1124876" y="1506558"/>
            <a:ext cx="0" cy="16093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>
            <a:endCxn id="18" idx="0"/>
          </p:cNvCxnSpPr>
          <p:nvPr/>
        </p:nvCxnSpPr>
        <p:spPr>
          <a:xfrm>
            <a:off x="5735782" y="1494683"/>
            <a:ext cx="0" cy="16057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100875" y="3115914"/>
            <a:ext cx="2048001" cy="76596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Cognition SNPs </a:t>
            </a:r>
            <a:br>
              <a:rPr lang="en-US" sz="1200" dirty="0"/>
            </a:br>
            <a:r>
              <a:rPr lang="en-US" sz="1200" dirty="0"/>
              <a:t>(p &lt; 0.05)</a:t>
            </a:r>
          </a:p>
          <a:p>
            <a:pPr algn="ctr"/>
            <a:r>
              <a:rPr lang="en-US" sz="1200" dirty="0"/>
              <a:t>Not associated with Education SNPs (p &gt; 0.5)</a:t>
            </a:r>
            <a:endParaRPr lang="en-SG" sz="1200" dirty="0"/>
          </a:p>
        </p:txBody>
      </p:sp>
      <p:sp>
        <p:nvSpPr>
          <p:cNvPr id="18" name="Rectangle 17"/>
          <p:cNvSpPr/>
          <p:nvPr/>
        </p:nvSpPr>
        <p:spPr>
          <a:xfrm>
            <a:off x="4714256" y="3100454"/>
            <a:ext cx="2043051" cy="76596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Education SNPs</a:t>
            </a:r>
            <a:br>
              <a:rPr lang="en-US" sz="1200" dirty="0"/>
            </a:br>
            <a:r>
              <a:rPr lang="en-US" sz="1200" dirty="0"/>
              <a:t>(p &lt; 0.05)</a:t>
            </a:r>
          </a:p>
          <a:p>
            <a:pPr algn="ctr"/>
            <a:r>
              <a:rPr lang="en-US" sz="1200" dirty="0"/>
              <a:t>Not associated with Cognition SNPs (p &gt; 0.5)</a:t>
            </a:r>
            <a:endParaRPr lang="en-SG" sz="1200" dirty="0"/>
          </a:p>
        </p:txBody>
      </p:sp>
      <p:sp>
        <p:nvSpPr>
          <p:cNvPr id="27" name="Rectangle 26"/>
          <p:cNvSpPr/>
          <p:nvPr/>
        </p:nvSpPr>
        <p:spPr>
          <a:xfrm>
            <a:off x="2406452" y="3115914"/>
            <a:ext cx="2048001" cy="76596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Fixed Effect Meta-Analysis</a:t>
            </a:r>
          </a:p>
          <a:p>
            <a:pPr algn="ctr"/>
            <a:r>
              <a:rPr lang="en-US" sz="1200" dirty="0"/>
              <a:t>Cognition + Education</a:t>
            </a:r>
          </a:p>
          <a:p>
            <a:pPr algn="ctr"/>
            <a:r>
              <a:rPr lang="en-US" sz="1200" dirty="0"/>
              <a:t>Het P thresholds </a:t>
            </a:r>
            <a:r>
              <a:rPr lang="en-SG" sz="1200" dirty="0"/>
              <a:t>0.5, 0.25, 0.1, 0.05, 0.01, 0.001</a:t>
            </a:r>
            <a:endParaRPr lang="en-US" sz="1200" dirty="0"/>
          </a:p>
        </p:txBody>
      </p:sp>
      <p:cxnSp>
        <p:nvCxnSpPr>
          <p:cNvPr id="30" name="Straight Arrow Connector 29"/>
          <p:cNvCxnSpPr/>
          <p:nvPr/>
        </p:nvCxnSpPr>
        <p:spPr>
          <a:xfrm>
            <a:off x="2775170" y="1500620"/>
            <a:ext cx="0" cy="162123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4204484" y="1506558"/>
            <a:ext cx="0" cy="16093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213755" y="127516"/>
            <a:ext cx="877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tage 1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213755" y="4925973"/>
            <a:ext cx="877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tage 2</a:t>
            </a:r>
          </a:p>
        </p:txBody>
      </p:sp>
      <p:sp>
        <p:nvSpPr>
          <p:cNvPr id="52" name="Rectangle 51"/>
          <p:cNvSpPr/>
          <p:nvPr/>
        </p:nvSpPr>
        <p:spPr>
          <a:xfrm>
            <a:off x="2645723" y="6314704"/>
            <a:ext cx="1566554" cy="505196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ASSET subset Meta-Analysis</a:t>
            </a:r>
            <a:endParaRPr lang="en-SG" sz="1200" dirty="0"/>
          </a:p>
        </p:txBody>
      </p:sp>
      <p:sp>
        <p:nvSpPr>
          <p:cNvPr id="7" name="Rectangle 6"/>
          <p:cNvSpPr/>
          <p:nvPr/>
        </p:nvSpPr>
        <p:spPr>
          <a:xfrm>
            <a:off x="126199" y="4448175"/>
            <a:ext cx="6609831" cy="32385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Preliminary Evaluation of Genetic Correlations</a:t>
            </a:r>
          </a:p>
        </p:txBody>
      </p:sp>
      <p:cxnSp>
        <p:nvCxnSpPr>
          <p:cNvPr id="16" name="Straight Arrow Connector 15"/>
          <p:cNvCxnSpPr>
            <a:stCxn id="17" idx="2"/>
          </p:cNvCxnSpPr>
          <p:nvPr/>
        </p:nvCxnSpPr>
        <p:spPr>
          <a:xfrm>
            <a:off x="1124876" y="3881874"/>
            <a:ext cx="0" cy="56630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>
            <a:stCxn id="27" idx="2"/>
            <a:endCxn id="7" idx="0"/>
          </p:cNvCxnSpPr>
          <p:nvPr/>
        </p:nvCxnSpPr>
        <p:spPr>
          <a:xfrm>
            <a:off x="3430453" y="3881874"/>
            <a:ext cx="662" cy="56630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stCxn id="18" idx="2"/>
          </p:cNvCxnSpPr>
          <p:nvPr/>
        </p:nvCxnSpPr>
        <p:spPr>
          <a:xfrm>
            <a:off x="5735782" y="3866414"/>
            <a:ext cx="0" cy="58176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/>
          <p:cNvSpPr/>
          <p:nvPr/>
        </p:nvSpPr>
        <p:spPr>
          <a:xfrm>
            <a:off x="213755" y="5295305"/>
            <a:ext cx="1314590" cy="5715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Cognition</a:t>
            </a:r>
          </a:p>
          <a:p>
            <a:pPr algn="ctr"/>
            <a:r>
              <a:rPr lang="en-US" sz="1200" dirty="0"/>
              <a:t>Lam et al., 2017</a:t>
            </a:r>
          </a:p>
        </p:txBody>
      </p:sp>
      <p:sp>
        <p:nvSpPr>
          <p:cNvPr id="66" name="Rectangle 65"/>
          <p:cNvSpPr/>
          <p:nvPr/>
        </p:nvSpPr>
        <p:spPr>
          <a:xfrm>
            <a:off x="2775170" y="5294934"/>
            <a:ext cx="1314590" cy="5715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Education</a:t>
            </a:r>
          </a:p>
          <a:p>
            <a:pPr algn="ctr"/>
            <a:r>
              <a:rPr lang="en-US" sz="1200" dirty="0" err="1"/>
              <a:t>Okbay</a:t>
            </a:r>
            <a:r>
              <a:rPr lang="en-US" sz="1200" dirty="0"/>
              <a:t> et al., 2016</a:t>
            </a:r>
          </a:p>
        </p:txBody>
      </p:sp>
      <p:sp>
        <p:nvSpPr>
          <p:cNvPr id="67" name="Rectangle 66"/>
          <p:cNvSpPr/>
          <p:nvPr/>
        </p:nvSpPr>
        <p:spPr>
          <a:xfrm>
            <a:off x="5421440" y="5294934"/>
            <a:ext cx="1314590" cy="5715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Schizophrenia</a:t>
            </a:r>
          </a:p>
          <a:p>
            <a:pPr algn="ctr"/>
            <a:r>
              <a:rPr lang="en-US" sz="1200" dirty="0"/>
              <a:t>PGC2, 2014</a:t>
            </a:r>
          </a:p>
        </p:txBody>
      </p:sp>
      <p:cxnSp>
        <p:nvCxnSpPr>
          <p:cNvPr id="40" name="Straight Arrow Connector 39"/>
          <p:cNvCxnSpPr>
            <a:stCxn id="66" idx="2"/>
            <a:endCxn id="52" idx="0"/>
          </p:cNvCxnSpPr>
          <p:nvPr/>
        </p:nvCxnSpPr>
        <p:spPr>
          <a:xfrm flipH="1">
            <a:off x="3429000" y="5866434"/>
            <a:ext cx="3465" cy="44827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stCxn id="36" idx="2"/>
            <a:endCxn id="52" idx="0"/>
          </p:cNvCxnSpPr>
          <p:nvPr/>
        </p:nvCxnSpPr>
        <p:spPr>
          <a:xfrm>
            <a:off x="871050" y="5866805"/>
            <a:ext cx="2557950" cy="44789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>
            <a:stCxn id="67" idx="2"/>
          </p:cNvCxnSpPr>
          <p:nvPr/>
        </p:nvCxnSpPr>
        <p:spPr>
          <a:xfrm flipH="1">
            <a:off x="3432465" y="5866434"/>
            <a:ext cx="2646270" cy="44827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>
            <a:stCxn id="52" idx="3"/>
            <a:endCxn id="80" idx="1"/>
          </p:cNvCxnSpPr>
          <p:nvPr/>
        </p:nvCxnSpPr>
        <p:spPr>
          <a:xfrm>
            <a:off x="4212277" y="6567302"/>
            <a:ext cx="97624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Rectangle 79"/>
          <p:cNvSpPr/>
          <p:nvPr/>
        </p:nvSpPr>
        <p:spPr>
          <a:xfrm>
            <a:off x="5188526" y="6314704"/>
            <a:ext cx="1547504" cy="505196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All markers</a:t>
            </a:r>
          </a:p>
          <a:p>
            <a:pPr algn="ctr"/>
            <a:r>
              <a:rPr lang="en-US" sz="1200" dirty="0"/>
              <a:t>7.3million (post-qc)</a:t>
            </a:r>
            <a:endParaRPr lang="en-SG" sz="1200" dirty="0"/>
          </a:p>
        </p:txBody>
      </p:sp>
      <p:sp>
        <p:nvSpPr>
          <p:cNvPr id="82" name="Rectangle 81"/>
          <p:cNvSpPr/>
          <p:nvPr/>
        </p:nvSpPr>
        <p:spPr>
          <a:xfrm>
            <a:off x="462079" y="7188777"/>
            <a:ext cx="1102231" cy="389783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Concordant</a:t>
            </a:r>
            <a:endParaRPr lang="en-SG" sz="1200" dirty="0"/>
          </a:p>
        </p:txBody>
      </p:sp>
      <p:sp>
        <p:nvSpPr>
          <p:cNvPr id="83" name="Rectangle 82"/>
          <p:cNvSpPr/>
          <p:nvPr/>
        </p:nvSpPr>
        <p:spPr>
          <a:xfrm>
            <a:off x="1744215" y="7188777"/>
            <a:ext cx="1102231" cy="389783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SZ outlier</a:t>
            </a:r>
            <a:endParaRPr lang="en-SG" sz="1200" dirty="0"/>
          </a:p>
        </p:txBody>
      </p:sp>
      <p:sp>
        <p:nvSpPr>
          <p:cNvPr id="84" name="Rectangle 83"/>
          <p:cNvSpPr/>
          <p:nvPr/>
        </p:nvSpPr>
        <p:spPr>
          <a:xfrm>
            <a:off x="2991993" y="7188777"/>
            <a:ext cx="1102231" cy="389783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Cog Outlier</a:t>
            </a:r>
            <a:endParaRPr lang="en-SG" sz="1200" dirty="0"/>
          </a:p>
        </p:txBody>
      </p:sp>
      <p:sp>
        <p:nvSpPr>
          <p:cNvPr id="85" name="Rectangle 84"/>
          <p:cNvSpPr/>
          <p:nvPr/>
        </p:nvSpPr>
        <p:spPr>
          <a:xfrm>
            <a:off x="4204484" y="7206713"/>
            <a:ext cx="1102231" cy="389783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 err="1" smtClean="0"/>
              <a:t>Edu</a:t>
            </a:r>
            <a:r>
              <a:rPr lang="en-US" sz="1200" dirty="0" smtClean="0"/>
              <a:t> Outlier</a:t>
            </a:r>
            <a:endParaRPr lang="en-SG" sz="1200" dirty="0"/>
          </a:p>
        </p:txBody>
      </p:sp>
      <p:grpSp>
        <p:nvGrpSpPr>
          <p:cNvPr id="14" name="Group 13"/>
          <p:cNvGrpSpPr/>
          <p:nvPr/>
        </p:nvGrpSpPr>
        <p:grpSpPr>
          <a:xfrm>
            <a:off x="114213" y="7617296"/>
            <a:ext cx="560610" cy="448677"/>
            <a:chOff x="114213" y="7831710"/>
            <a:chExt cx="560610" cy="448677"/>
          </a:xfrm>
        </p:grpSpPr>
        <p:sp>
          <p:nvSpPr>
            <p:cNvPr id="100" name="Rectangle 99"/>
            <p:cNvSpPr/>
            <p:nvPr/>
          </p:nvSpPr>
          <p:spPr>
            <a:xfrm>
              <a:off x="126197" y="7880350"/>
              <a:ext cx="72000" cy="72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5" name="Oval 114"/>
            <p:cNvSpPr/>
            <p:nvPr/>
          </p:nvSpPr>
          <p:spPr>
            <a:xfrm>
              <a:off x="126197" y="8013750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" name="Rectangle 119"/>
            <p:cNvSpPr/>
            <p:nvPr/>
          </p:nvSpPr>
          <p:spPr>
            <a:xfrm rot="18720000">
              <a:off x="114213" y="8159749"/>
              <a:ext cx="72000" cy="72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126199" y="7831710"/>
              <a:ext cx="4331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Cognition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126275" y="7965111"/>
              <a:ext cx="44435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Education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126275" y="8111110"/>
              <a:ext cx="54854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 dirty="0"/>
                <a:t>Schizophrenia</a:t>
              </a:r>
            </a:p>
          </p:txBody>
        </p:sp>
      </p:grpSp>
      <p:sp>
        <p:nvSpPr>
          <p:cNvPr id="117" name="Rectangle 116"/>
          <p:cNvSpPr/>
          <p:nvPr/>
        </p:nvSpPr>
        <p:spPr>
          <a:xfrm>
            <a:off x="126197" y="9410700"/>
            <a:ext cx="6609833" cy="28575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Functional Characterization of Loci</a:t>
            </a:r>
            <a:endParaRPr lang="en-US" sz="1200" dirty="0"/>
          </a:p>
        </p:txBody>
      </p:sp>
      <p:cxnSp>
        <p:nvCxnSpPr>
          <p:cNvPr id="119" name="Straight Arrow Connector 118"/>
          <p:cNvCxnSpPr/>
          <p:nvPr/>
        </p:nvCxnSpPr>
        <p:spPr>
          <a:xfrm>
            <a:off x="963767" y="8880790"/>
            <a:ext cx="0" cy="51378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/>
          <p:cNvCxnSpPr/>
          <p:nvPr/>
        </p:nvCxnSpPr>
        <p:spPr>
          <a:xfrm>
            <a:off x="2307352" y="8896914"/>
            <a:ext cx="0" cy="51378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Arrow Connector 125"/>
          <p:cNvCxnSpPr/>
          <p:nvPr/>
        </p:nvCxnSpPr>
        <p:spPr>
          <a:xfrm>
            <a:off x="3612570" y="8896914"/>
            <a:ext cx="0" cy="52648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4" name="Straight Arrow Connector 1023"/>
          <p:cNvCxnSpPr/>
          <p:nvPr/>
        </p:nvCxnSpPr>
        <p:spPr>
          <a:xfrm>
            <a:off x="4825546" y="8885616"/>
            <a:ext cx="0" cy="53638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0" name="Straight Arrow Connector 1029"/>
          <p:cNvCxnSpPr>
            <a:stCxn id="80" idx="2"/>
          </p:cNvCxnSpPr>
          <p:nvPr/>
        </p:nvCxnSpPr>
        <p:spPr>
          <a:xfrm>
            <a:off x="5962278" y="6819900"/>
            <a:ext cx="0" cy="25908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2" name="Straight Arrow Connector 1031"/>
          <p:cNvCxnSpPr>
            <a:stCxn id="52" idx="2"/>
            <a:endCxn id="82" idx="0"/>
          </p:cNvCxnSpPr>
          <p:nvPr/>
        </p:nvCxnSpPr>
        <p:spPr>
          <a:xfrm flipH="1">
            <a:off x="1013195" y="6819900"/>
            <a:ext cx="2415805" cy="36887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4" name="Straight Arrow Connector 1033"/>
          <p:cNvCxnSpPr>
            <a:stCxn id="52" idx="2"/>
            <a:endCxn id="83" idx="0"/>
          </p:cNvCxnSpPr>
          <p:nvPr/>
        </p:nvCxnSpPr>
        <p:spPr>
          <a:xfrm flipH="1">
            <a:off x="2295331" y="6819900"/>
            <a:ext cx="1133669" cy="36887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6" name="Straight Arrow Connector 1035"/>
          <p:cNvCxnSpPr>
            <a:stCxn id="52" idx="2"/>
            <a:endCxn id="84" idx="0"/>
          </p:cNvCxnSpPr>
          <p:nvPr/>
        </p:nvCxnSpPr>
        <p:spPr>
          <a:xfrm>
            <a:off x="3429000" y="6819900"/>
            <a:ext cx="114109" cy="36887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8" name="Straight Arrow Connector 1037"/>
          <p:cNvCxnSpPr>
            <a:stCxn id="52" idx="2"/>
            <a:endCxn id="85" idx="0"/>
          </p:cNvCxnSpPr>
          <p:nvPr/>
        </p:nvCxnSpPr>
        <p:spPr>
          <a:xfrm>
            <a:off x="3429000" y="6819900"/>
            <a:ext cx="1326600" cy="38681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5662607" y="5866805"/>
            <a:ext cx="8627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 = 77,096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2598647" y="35183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Figure </a:t>
            </a:r>
            <a:r>
              <a:rPr lang="en-US" sz="1200" b="1" dirty="0" smtClean="0"/>
              <a:t>1</a:t>
            </a:r>
            <a:endParaRPr lang="en-SG" sz="1200" b="1" dirty="0"/>
          </a:p>
        </p:txBody>
      </p:sp>
      <p:grpSp>
        <p:nvGrpSpPr>
          <p:cNvPr id="57" name="Group 56"/>
          <p:cNvGrpSpPr/>
          <p:nvPr/>
        </p:nvGrpSpPr>
        <p:grpSpPr>
          <a:xfrm>
            <a:off x="423767" y="7740387"/>
            <a:ext cx="1080000" cy="1080000"/>
            <a:chOff x="330613" y="518818"/>
            <a:chExt cx="2708493" cy="3064843"/>
          </a:xfrm>
        </p:grpSpPr>
        <p:grpSp>
          <p:nvGrpSpPr>
            <p:cNvPr id="58" name="Group 57"/>
            <p:cNvGrpSpPr/>
            <p:nvPr/>
          </p:nvGrpSpPr>
          <p:grpSpPr>
            <a:xfrm>
              <a:off x="330613" y="1354999"/>
              <a:ext cx="2708493" cy="2228662"/>
              <a:chOff x="1711106" y="516047"/>
              <a:chExt cx="3503691" cy="2770360"/>
            </a:xfrm>
          </p:grpSpPr>
          <p:cxnSp>
            <p:nvCxnSpPr>
              <p:cNvPr id="73" name="Straight Arrow Connector 72"/>
              <p:cNvCxnSpPr/>
              <p:nvPr/>
            </p:nvCxnSpPr>
            <p:spPr>
              <a:xfrm flipH="1" flipV="1">
                <a:off x="3419946" y="516047"/>
                <a:ext cx="9054" cy="27703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Straight Arrow Connector 73"/>
              <p:cNvCxnSpPr/>
              <p:nvPr/>
            </p:nvCxnSpPr>
            <p:spPr>
              <a:xfrm flipV="1">
                <a:off x="1711106" y="2869949"/>
                <a:ext cx="3503691" cy="905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Group 58"/>
            <p:cNvGrpSpPr/>
            <p:nvPr/>
          </p:nvGrpSpPr>
          <p:grpSpPr>
            <a:xfrm>
              <a:off x="734518" y="1834967"/>
              <a:ext cx="539646" cy="160514"/>
              <a:chOff x="734518" y="1834967"/>
              <a:chExt cx="539646" cy="160514"/>
            </a:xfrm>
          </p:grpSpPr>
          <p:sp>
            <p:nvSpPr>
              <p:cNvPr id="71" name="Rectangle 70"/>
              <p:cNvSpPr/>
              <p:nvPr/>
            </p:nvSpPr>
            <p:spPr>
              <a:xfrm>
                <a:off x="924772" y="1834967"/>
                <a:ext cx="168305" cy="16051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72" name="Straight Connector 71"/>
              <p:cNvCxnSpPr/>
              <p:nvPr/>
            </p:nvCxnSpPr>
            <p:spPr>
              <a:xfrm>
                <a:off x="734518" y="1915224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0" name="Group 59"/>
            <p:cNvGrpSpPr/>
            <p:nvPr/>
          </p:nvGrpSpPr>
          <p:grpSpPr>
            <a:xfrm>
              <a:off x="734518" y="2224088"/>
              <a:ext cx="539646" cy="155457"/>
              <a:chOff x="734518" y="2224088"/>
              <a:chExt cx="539646" cy="155457"/>
            </a:xfrm>
          </p:grpSpPr>
          <p:sp>
            <p:nvSpPr>
              <p:cNvPr id="69" name="Oval 68"/>
              <p:cNvSpPr/>
              <p:nvPr/>
            </p:nvSpPr>
            <p:spPr>
              <a:xfrm>
                <a:off x="929298" y="2224088"/>
                <a:ext cx="159252" cy="155457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70" name="Straight Connector 69"/>
              <p:cNvCxnSpPr/>
              <p:nvPr/>
            </p:nvCxnSpPr>
            <p:spPr>
              <a:xfrm>
                <a:off x="734518" y="2301816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1" name="Group 60"/>
            <p:cNvGrpSpPr/>
            <p:nvPr/>
          </p:nvGrpSpPr>
          <p:grpSpPr>
            <a:xfrm>
              <a:off x="738779" y="2648806"/>
              <a:ext cx="539646" cy="168305"/>
              <a:chOff x="738779" y="2648806"/>
              <a:chExt cx="539646" cy="168305"/>
            </a:xfrm>
          </p:grpSpPr>
          <p:sp>
            <p:nvSpPr>
              <p:cNvPr id="64" name="Rectangle 63"/>
              <p:cNvSpPr/>
              <p:nvPr/>
            </p:nvSpPr>
            <p:spPr>
              <a:xfrm rot="18720000">
                <a:off x="924771" y="2652702"/>
                <a:ext cx="168305" cy="16051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5" name="Straight Connector 64"/>
              <p:cNvCxnSpPr/>
              <p:nvPr/>
            </p:nvCxnSpPr>
            <p:spPr>
              <a:xfrm>
                <a:off x="738779" y="2728788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3" name="TextBox 62"/>
            <p:cNvSpPr txBox="1"/>
            <p:nvPr/>
          </p:nvSpPr>
          <p:spPr>
            <a:xfrm>
              <a:off x="848778" y="518818"/>
              <a:ext cx="1689252" cy="61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Concordant</a:t>
              </a:r>
              <a:endParaRPr lang="en-US" sz="800" dirty="0"/>
            </a:p>
          </p:txBody>
        </p:sp>
      </p:grpSp>
      <p:grpSp>
        <p:nvGrpSpPr>
          <p:cNvPr id="75" name="Group 74"/>
          <p:cNvGrpSpPr/>
          <p:nvPr/>
        </p:nvGrpSpPr>
        <p:grpSpPr>
          <a:xfrm>
            <a:off x="1772816" y="7737936"/>
            <a:ext cx="1080000" cy="1080000"/>
            <a:chOff x="3786613" y="518818"/>
            <a:chExt cx="2708493" cy="3064843"/>
          </a:xfrm>
        </p:grpSpPr>
        <p:grpSp>
          <p:nvGrpSpPr>
            <p:cNvPr id="76" name="Group 75"/>
            <p:cNvGrpSpPr/>
            <p:nvPr/>
          </p:nvGrpSpPr>
          <p:grpSpPr>
            <a:xfrm>
              <a:off x="3786613" y="1354999"/>
              <a:ext cx="2708493" cy="2228662"/>
              <a:chOff x="1711106" y="516047"/>
              <a:chExt cx="3503691" cy="2770360"/>
            </a:xfrm>
          </p:grpSpPr>
          <p:cxnSp>
            <p:nvCxnSpPr>
              <p:cNvPr id="92" name="Straight Arrow Connector 91"/>
              <p:cNvCxnSpPr/>
              <p:nvPr/>
            </p:nvCxnSpPr>
            <p:spPr>
              <a:xfrm flipH="1" flipV="1">
                <a:off x="3419946" y="516047"/>
                <a:ext cx="9054" cy="27703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3" name="Straight Arrow Connector 92"/>
              <p:cNvCxnSpPr/>
              <p:nvPr/>
            </p:nvCxnSpPr>
            <p:spPr>
              <a:xfrm flipV="1">
                <a:off x="1711106" y="2869949"/>
                <a:ext cx="3503691" cy="905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7" name="Group 76"/>
            <p:cNvGrpSpPr/>
            <p:nvPr/>
          </p:nvGrpSpPr>
          <p:grpSpPr>
            <a:xfrm>
              <a:off x="4299793" y="1802880"/>
              <a:ext cx="539646" cy="160514"/>
              <a:chOff x="734518" y="1834967"/>
              <a:chExt cx="539646" cy="160514"/>
            </a:xfrm>
          </p:grpSpPr>
          <p:sp>
            <p:nvSpPr>
              <p:cNvPr id="90" name="Rectangle 89"/>
              <p:cNvSpPr/>
              <p:nvPr/>
            </p:nvSpPr>
            <p:spPr>
              <a:xfrm>
                <a:off x="924772" y="1834967"/>
                <a:ext cx="168305" cy="16051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500"/>
              </a:p>
            </p:txBody>
          </p:sp>
          <p:cxnSp>
            <p:nvCxnSpPr>
              <p:cNvPr id="91" name="Straight Connector 90"/>
              <p:cNvCxnSpPr/>
              <p:nvPr/>
            </p:nvCxnSpPr>
            <p:spPr>
              <a:xfrm>
                <a:off x="734518" y="1915224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 77"/>
            <p:cNvGrpSpPr/>
            <p:nvPr/>
          </p:nvGrpSpPr>
          <p:grpSpPr>
            <a:xfrm>
              <a:off x="4299793" y="2192001"/>
              <a:ext cx="539646" cy="155457"/>
              <a:chOff x="734518" y="2224088"/>
              <a:chExt cx="539646" cy="155457"/>
            </a:xfrm>
          </p:grpSpPr>
          <p:sp>
            <p:nvSpPr>
              <p:cNvPr id="88" name="Oval 87"/>
              <p:cNvSpPr/>
              <p:nvPr/>
            </p:nvSpPr>
            <p:spPr>
              <a:xfrm>
                <a:off x="929298" y="2224088"/>
                <a:ext cx="159252" cy="155457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500"/>
              </a:p>
            </p:txBody>
          </p:sp>
          <p:cxnSp>
            <p:nvCxnSpPr>
              <p:cNvPr id="89" name="Straight Connector 88"/>
              <p:cNvCxnSpPr/>
              <p:nvPr/>
            </p:nvCxnSpPr>
            <p:spPr>
              <a:xfrm>
                <a:off x="734518" y="2301816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9" name="Group 78"/>
            <p:cNvGrpSpPr/>
            <p:nvPr/>
          </p:nvGrpSpPr>
          <p:grpSpPr>
            <a:xfrm>
              <a:off x="5265214" y="2609802"/>
              <a:ext cx="539646" cy="168305"/>
              <a:chOff x="738779" y="2648806"/>
              <a:chExt cx="539646" cy="168305"/>
            </a:xfrm>
          </p:grpSpPr>
          <p:sp>
            <p:nvSpPr>
              <p:cNvPr id="86" name="Rectangle 85"/>
              <p:cNvSpPr/>
              <p:nvPr/>
            </p:nvSpPr>
            <p:spPr>
              <a:xfrm rot="18720000">
                <a:off x="924771" y="2652702"/>
                <a:ext cx="168305" cy="16051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500"/>
              </a:p>
            </p:txBody>
          </p:sp>
          <p:cxnSp>
            <p:nvCxnSpPr>
              <p:cNvPr id="87" name="Straight Connector 86"/>
              <p:cNvCxnSpPr/>
              <p:nvPr/>
            </p:nvCxnSpPr>
            <p:spPr>
              <a:xfrm>
                <a:off x="738779" y="2728788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1" name="TextBox 80"/>
            <p:cNvSpPr txBox="1"/>
            <p:nvPr/>
          </p:nvSpPr>
          <p:spPr>
            <a:xfrm>
              <a:off x="4425291" y="518818"/>
              <a:ext cx="1484227" cy="611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SZ Outlier</a:t>
              </a:r>
              <a:endParaRPr lang="en-US" sz="800" dirty="0"/>
            </a:p>
          </p:txBody>
        </p:sp>
      </p:grpSp>
      <p:grpSp>
        <p:nvGrpSpPr>
          <p:cNvPr id="94" name="Group 93"/>
          <p:cNvGrpSpPr/>
          <p:nvPr/>
        </p:nvGrpSpPr>
        <p:grpSpPr>
          <a:xfrm>
            <a:off x="3081974" y="7761432"/>
            <a:ext cx="1080000" cy="1080000"/>
            <a:chOff x="3786614" y="5588243"/>
            <a:chExt cx="2708493" cy="2813371"/>
          </a:xfrm>
        </p:grpSpPr>
        <p:grpSp>
          <p:nvGrpSpPr>
            <p:cNvPr id="95" name="Group 94"/>
            <p:cNvGrpSpPr/>
            <p:nvPr/>
          </p:nvGrpSpPr>
          <p:grpSpPr>
            <a:xfrm>
              <a:off x="3786614" y="6172952"/>
              <a:ext cx="2708493" cy="2228662"/>
              <a:chOff x="1711106" y="516047"/>
              <a:chExt cx="3503691" cy="2770360"/>
            </a:xfrm>
          </p:grpSpPr>
          <p:cxnSp>
            <p:nvCxnSpPr>
              <p:cNvPr id="107" name="Straight Arrow Connector 106"/>
              <p:cNvCxnSpPr/>
              <p:nvPr/>
            </p:nvCxnSpPr>
            <p:spPr>
              <a:xfrm flipH="1" flipV="1">
                <a:off x="3419946" y="516047"/>
                <a:ext cx="9054" cy="27703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Straight Arrow Connector 107"/>
              <p:cNvCxnSpPr/>
              <p:nvPr/>
            </p:nvCxnSpPr>
            <p:spPr>
              <a:xfrm flipV="1">
                <a:off x="1711106" y="2869949"/>
                <a:ext cx="3503691" cy="905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oup 95"/>
            <p:cNvGrpSpPr/>
            <p:nvPr/>
          </p:nvGrpSpPr>
          <p:grpSpPr>
            <a:xfrm>
              <a:off x="5265707" y="6848228"/>
              <a:ext cx="539646" cy="160514"/>
              <a:chOff x="734518" y="1834967"/>
              <a:chExt cx="539646" cy="160514"/>
            </a:xfrm>
          </p:grpSpPr>
          <p:sp>
            <p:nvSpPr>
              <p:cNvPr id="105" name="Rectangle 104"/>
              <p:cNvSpPr/>
              <p:nvPr/>
            </p:nvSpPr>
            <p:spPr>
              <a:xfrm>
                <a:off x="924772" y="1834967"/>
                <a:ext cx="168305" cy="16051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06" name="Straight Connector 105"/>
              <p:cNvCxnSpPr/>
              <p:nvPr/>
            </p:nvCxnSpPr>
            <p:spPr>
              <a:xfrm>
                <a:off x="734518" y="1915224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7" name="Group 96"/>
            <p:cNvGrpSpPr/>
            <p:nvPr/>
          </p:nvGrpSpPr>
          <p:grpSpPr>
            <a:xfrm>
              <a:off x="4215136" y="7202432"/>
              <a:ext cx="539646" cy="155457"/>
              <a:chOff x="734518" y="2224088"/>
              <a:chExt cx="539646" cy="155457"/>
            </a:xfrm>
          </p:grpSpPr>
          <p:sp>
            <p:nvSpPr>
              <p:cNvPr id="103" name="Oval 102"/>
              <p:cNvSpPr/>
              <p:nvPr/>
            </p:nvSpPr>
            <p:spPr>
              <a:xfrm>
                <a:off x="929298" y="2224088"/>
                <a:ext cx="159252" cy="155457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04" name="Straight Connector 103"/>
              <p:cNvCxnSpPr/>
              <p:nvPr/>
            </p:nvCxnSpPr>
            <p:spPr>
              <a:xfrm>
                <a:off x="734518" y="2301816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8" name="Group 97"/>
            <p:cNvGrpSpPr/>
            <p:nvPr/>
          </p:nvGrpSpPr>
          <p:grpSpPr>
            <a:xfrm>
              <a:off x="4219397" y="7627150"/>
              <a:ext cx="539646" cy="168305"/>
              <a:chOff x="738779" y="2648806"/>
              <a:chExt cx="539646" cy="168305"/>
            </a:xfrm>
          </p:grpSpPr>
          <p:sp>
            <p:nvSpPr>
              <p:cNvPr id="101" name="Rectangle 100"/>
              <p:cNvSpPr/>
              <p:nvPr/>
            </p:nvSpPr>
            <p:spPr>
              <a:xfrm rot="18720000">
                <a:off x="924771" y="2652702"/>
                <a:ext cx="168305" cy="16051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02" name="Straight Connector 101"/>
              <p:cNvCxnSpPr/>
              <p:nvPr/>
            </p:nvCxnSpPr>
            <p:spPr>
              <a:xfrm>
                <a:off x="738779" y="2728788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9" name="TextBox 98"/>
            <p:cNvSpPr txBox="1"/>
            <p:nvPr/>
          </p:nvSpPr>
          <p:spPr>
            <a:xfrm>
              <a:off x="4344799" y="5588243"/>
              <a:ext cx="1608850" cy="5612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Cog outlier</a:t>
              </a:r>
              <a:endParaRPr lang="en-US" sz="800" dirty="0"/>
            </a:p>
          </p:txBody>
        </p:sp>
      </p:grpSp>
      <p:grpSp>
        <p:nvGrpSpPr>
          <p:cNvPr id="109" name="Group 108"/>
          <p:cNvGrpSpPr/>
          <p:nvPr/>
        </p:nvGrpSpPr>
        <p:grpSpPr>
          <a:xfrm>
            <a:off x="4285546" y="7747851"/>
            <a:ext cx="1080000" cy="1080000"/>
            <a:chOff x="356859" y="5588243"/>
            <a:chExt cx="2708493" cy="2813371"/>
          </a:xfrm>
        </p:grpSpPr>
        <p:grpSp>
          <p:nvGrpSpPr>
            <p:cNvPr id="110" name="Group 109"/>
            <p:cNvGrpSpPr/>
            <p:nvPr/>
          </p:nvGrpSpPr>
          <p:grpSpPr>
            <a:xfrm>
              <a:off x="356859" y="6172952"/>
              <a:ext cx="2708493" cy="2228662"/>
              <a:chOff x="1711106" y="516047"/>
              <a:chExt cx="3503691" cy="2770360"/>
            </a:xfrm>
          </p:grpSpPr>
          <p:cxnSp>
            <p:nvCxnSpPr>
              <p:cNvPr id="130" name="Straight Arrow Connector 129"/>
              <p:cNvCxnSpPr/>
              <p:nvPr/>
            </p:nvCxnSpPr>
            <p:spPr>
              <a:xfrm flipH="1" flipV="1">
                <a:off x="3419946" y="516047"/>
                <a:ext cx="9054" cy="277036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1" name="Straight Arrow Connector 130"/>
              <p:cNvCxnSpPr/>
              <p:nvPr/>
            </p:nvCxnSpPr>
            <p:spPr>
              <a:xfrm flipV="1">
                <a:off x="1711106" y="2869949"/>
                <a:ext cx="3503691" cy="905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1" name="Group 110"/>
            <p:cNvGrpSpPr/>
            <p:nvPr/>
          </p:nvGrpSpPr>
          <p:grpSpPr>
            <a:xfrm>
              <a:off x="730257" y="6848678"/>
              <a:ext cx="539646" cy="160514"/>
              <a:chOff x="734518" y="1834967"/>
              <a:chExt cx="539646" cy="160514"/>
            </a:xfrm>
          </p:grpSpPr>
          <p:sp>
            <p:nvSpPr>
              <p:cNvPr id="128" name="Rectangle 127"/>
              <p:cNvSpPr/>
              <p:nvPr/>
            </p:nvSpPr>
            <p:spPr>
              <a:xfrm>
                <a:off x="924772" y="1834967"/>
                <a:ext cx="168305" cy="16051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9" name="Straight Connector 128"/>
              <p:cNvCxnSpPr/>
              <p:nvPr/>
            </p:nvCxnSpPr>
            <p:spPr>
              <a:xfrm>
                <a:off x="734518" y="1915224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2" name="Group 111"/>
            <p:cNvGrpSpPr/>
            <p:nvPr/>
          </p:nvGrpSpPr>
          <p:grpSpPr>
            <a:xfrm>
              <a:off x="1958011" y="7274228"/>
              <a:ext cx="539646" cy="155457"/>
              <a:chOff x="734518" y="2224088"/>
              <a:chExt cx="539646" cy="155457"/>
            </a:xfrm>
          </p:grpSpPr>
          <p:sp>
            <p:nvSpPr>
              <p:cNvPr id="125" name="Oval 124"/>
              <p:cNvSpPr/>
              <p:nvPr/>
            </p:nvSpPr>
            <p:spPr>
              <a:xfrm>
                <a:off x="929298" y="2224088"/>
                <a:ext cx="159252" cy="155457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7" name="Straight Connector 126"/>
              <p:cNvCxnSpPr/>
              <p:nvPr/>
            </p:nvCxnSpPr>
            <p:spPr>
              <a:xfrm>
                <a:off x="734518" y="2301816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3" name="Group 112"/>
            <p:cNvGrpSpPr/>
            <p:nvPr/>
          </p:nvGrpSpPr>
          <p:grpSpPr>
            <a:xfrm>
              <a:off x="734518" y="7662517"/>
              <a:ext cx="539646" cy="168305"/>
              <a:chOff x="738779" y="2648806"/>
              <a:chExt cx="539646" cy="168305"/>
            </a:xfrm>
          </p:grpSpPr>
          <p:sp>
            <p:nvSpPr>
              <p:cNvPr id="118" name="Rectangle 117"/>
              <p:cNvSpPr/>
              <p:nvPr/>
            </p:nvSpPr>
            <p:spPr>
              <a:xfrm rot="18720000">
                <a:off x="924771" y="2652702"/>
                <a:ext cx="168305" cy="16051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1" name="Straight Connector 120"/>
              <p:cNvCxnSpPr/>
              <p:nvPr/>
            </p:nvCxnSpPr>
            <p:spPr>
              <a:xfrm>
                <a:off x="738779" y="2728788"/>
                <a:ext cx="53964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4" name="TextBox 113"/>
            <p:cNvSpPr txBox="1"/>
            <p:nvPr/>
          </p:nvSpPr>
          <p:spPr>
            <a:xfrm>
              <a:off x="898442" y="5588243"/>
              <a:ext cx="1645031" cy="5612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Edu</a:t>
              </a:r>
              <a:r>
                <a:rPr lang="en-US" sz="800" dirty="0" smtClean="0"/>
                <a:t> Outlier</a:t>
              </a:r>
              <a:endParaRPr 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314259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Rectangle 94"/>
          <p:cNvSpPr/>
          <p:nvPr/>
        </p:nvSpPr>
        <p:spPr>
          <a:xfrm>
            <a:off x="3429000" y="6300430"/>
            <a:ext cx="3429000" cy="360557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Rectangle 93"/>
          <p:cNvSpPr/>
          <p:nvPr/>
        </p:nvSpPr>
        <p:spPr>
          <a:xfrm>
            <a:off x="0" y="5506631"/>
            <a:ext cx="3428998" cy="439936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/>
          <p:cNvSpPr/>
          <p:nvPr/>
        </p:nvSpPr>
        <p:spPr>
          <a:xfrm>
            <a:off x="3435121" y="2792760"/>
            <a:ext cx="3422878" cy="350767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/>
          <p:cNvSpPr/>
          <p:nvPr/>
        </p:nvSpPr>
        <p:spPr>
          <a:xfrm>
            <a:off x="-1" y="2804177"/>
            <a:ext cx="3428999" cy="2724887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/>
          <p:cNvSpPr/>
          <p:nvPr/>
        </p:nvSpPr>
        <p:spPr>
          <a:xfrm>
            <a:off x="0" y="1886782"/>
            <a:ext cx="6857999" cy="905978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1556792" y="231830"/>
            <a:ext cx="3983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unctional characterization of GWAS loci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416906" y="1424991"/>
            <a:ext cx="1102231" cy="389783"/>
          </a:xfrm>
          <a:prstGeom prst="rect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Concordant</a:t>
            </a:r>
            <a:endParaRPr lang="en-SG" sz="1200" dirty="0"/>
          </a:p>
        </p:txBody>
      </p:sp>
      <p:sp>
        <p:nvSpPr>
          <p:cNvPr id="6" name="Rectangle 5"/>
          <p:cNvSpPr/>
          <p:nvPr/>
        </p:nvSpPr>
        <p:spPr>
          <a:xfrm>
            <a:off x="1642348" y="1424991"/>
            <a:ext cx="1102231" cy="389783"/>
          </a:xfrm>
          <a:prstGeom prst="rect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SZ outlier</a:t>
            </a:r>
            <a:endParaRPr lang="en-SG" sz="1200" dirty="0"/>
          </a:p>
        </p:txBody>
      </p:sp>
      <p:sp>
        <p:nvSpPr>
          <p:cNvPr id="7" name="Rectangle 6"/>
          <p:cNvSpPr/>
          <p:nvPr/>
        </p:nvSpPr>
        <p:spPr>
          <a:xfrm>
            <a:off x="2890126" y="1424991"/>
            <a:ext cx="1102231" cy="389783"/>
          </a:xfrm>
          <a:prstGeom prst="rect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 err="1" smtClean="0"/>
              <a:t>Edu</a:t>
            </a:r>
            <a:r>
              <a:rPr lang="en-US" sz="1200" dirty="0" smtClean="0"/>
              <a:t> outlier</a:t>
            </a:r>
            <a:endParaRPr lang="en-SG" sz="1200" dirty="0"/>
          </a:p>
        </p:txBody>
      </p:sp>
      <p:sp>
        <p:nvSpPr>
          <p:cNvPr id="8" name="Rectangle 7"/>
          <p:cNvSpPr/>
          <p:nvPr/>
        </p:nvSpPr>
        <p:spPr>
          <a:xfrm>
            <a:off x="4119695" y="1424990"/>
            <a:ext cx="1102231" cy="389783"/>
          </a:xfrm>
          <a:prstGeom prst="rect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Cog outlier</a:t>
            </a:r>
            <a:endParaRPr lang="en-SG" sz="1200" dirty="0"/>
          </a:p>
        </p:txBody>
      </p:sp>
      <p:sp>
        <p:nvSpPr>
          <p:cNvPr id="9" name="Rectangle 8"/>
          <p:cNvSpPr/>
          <p:nvPr/>
        </p:nvSpPr>
        <p:spPr>
          <a:xfrm>
            <a:off x="2877882" y="601162"/>
            <a:ext cx="1102231" cy="389783"/>
          </a:xfrm>
          <a:prstGeom prst="rect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ALL</a:t>
            </a:r>
            <a:endParaRPr lang="en-SG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340731" y="1900929"/>
            <a:ext cx="3386504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Combined Lead SNPs and Independent Loci across ASSET meta-analysis subsets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3433889" y="2975765"/>
            <a:ext cx="3284035" cy="646331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Combined ASSET loci with earlier schizophrenia, education and cognition loci (+/- 500kb threshold) resulting in 278 loci </a:t>
            </a:r>
            <a:endParaRPr lang="en-US" sz="1200" dirty="0"/>
          </a:p>
        </p:txBody>
      </p:sp>
      <p:cxnSp>
        <p:nvCxnSpPr>
          <p:cNvPr id="30" name="Straight Arrow Connector 29"/>
          <p:cNvCxnSpPr>
            <a:stCxn id="11" idx="3"/>
            <a:endCxn id="31" idx="1"/>
          </p:cNvCxnSpPr>
          <p:nvPr/>
        </p:nvCxnSpPr>
        <p:spPr>
          <a:xfrm flipV="1">
            <a:off x="3727235" y="2131761"/>
            <a:ext cx="494643" cy="1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4221878" y="1900928"/>
            <a:ext cx="2203215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Variant Effect Predictor Annotations of clumped loci</a:t>
            </a:r>
            <a:endParaRPr lang="en-US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407427" y="2975764"/>
            <a:ext cx="2736304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MAGMA Gene property/Tissue Expression Analysis for GTEXv7 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409555" y="3660320"/>
            <a:ext cx="2736304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Over representation of Brain Tissue Expression</a:t>
            </a:r>
            <a:endParaRPr lang="en-US" sz="1200" dirty="0"/>
          </a:p>
        </p:txBody>
      </p:sp>
      <p:cxnSp>
        <p:nvCxnSpPr>
          <p:cNvPr id="38" name="Straight Arrow Connector 37"/>
          <p:cNvCxnSpPr>
            <a:stCxn id="35" idx="2"/>
            <a:endCxn id="36" idx="0"/>
          </p:cNvCxnSpPr>
          <p:nvPr/>
        </p:nvCxnSpPr>
        <p:spPr>
          <a:xfrm>
            <a:off x="1775579" y="3437429"/>
            <a:ext cx="2128" cy="222891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4310640" y="4057138"/>
            <a:ext cx="1525817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ROADMAP Brain tissue annotations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3508803" y="4734115"/>
            <a:ext cx="3129492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308 SNPs with post. </a:t>
            </a:r>
            <a:r>
              <a:rPr lang="en-US" sz="1200" dirty="0" err="1" smtClean="0"/>
              <a:t>Prob</a:t>
            </a:r>
            <a:r>
              <a:rPr lang="en-US" sz="1200" dirty="0" smtClean="0"/>
              <a:t> &gt; .8</a:t>
            </a:r>
            <a:endParaRPr lang="en-US" sz="1200" dirty="0"/>
          </a:p>
        </p:txBody>
      </p:sp>
      <p:cxnSp>
        <p:nvCxnSpPr>
          <p:cNvPr id="42" name="Straight Arrow Connector 41"/>
          <p:cNvCxnSpPr>
            <a:stCxn id="28" idx="2"/>
            <a:endCxn id="39" idx="0"/>
          </p:cNvCxnSpPr>
          <p:nvPr/>
        </p:nvCxnSpPr>
        <p:spPr>
          <a:xfrm flipH="1">
            <a:off x="5073549" y="3622096"/>
            <a:ext cx="2358" cy="435042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3484006" y="5226699"/>
            <a:ext cx="3179084" cy="28701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Variant Effect Predictor Annotations of 308 SNPs</a:t>
            </a:r>
            <a:endParaRPr lang="en-US" sz="1200" dirty="0"/>
          </a:p>
        </p:txBody>
      </p:sp>
      <p:cxnSp>
        <p:nvCxnSpPr>
          <p:cNvPr id="48" name="Straight Arrow Connector 47"/>
          <p:cNvCxnSpPr>
            <a:stCxn id="40" idx="2"/>
            <a:endCxn id="46" idx="0"/>
          </p:cNvCxnSpPr>
          <p:nvPr/>
        </p:nvCxnSpPr>
        <p:spPr>
          <a:xfrm flipH="1">
            <a:off x="5073548" y="5011114"/>
            <a:ext cx="1" cy="215585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417277" y="4304928"/>
            <a:ext cx="2736304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-</a:t>
            </a:r>
            <a:r>
              <a:rPr lang="en-US" sz="1200" dirty="0" err="1" smtClean="0"/>
              <a:t>Predixcan</a:t>
            </a:r>
            <a:r>
              <a:rPr lang="en-US" sz="1200" dirty="0" smtClean="0"/>
              <a:t> of GTEXv7 Brain Tissue + CMC DLPFC Tissue</a:t>
            </a:r>
            <a:endParaRPr lang="en-US" sz="1200" dirty="0"/>
          </a:p>
        </p:txBody>
      </p:sp>
      <p:sp>
        <p:nvSpPr>
          <p:cNvPr id="51" name="TextBox 50"/>
          <p:cNvSpPr txBox="1"/>
          <p:nvPr/>
        </p:nvSpPr>
        <p:spPr>
          <a:xfrm>
            <a:off x="417277" y="4953000"/>
            <a:ext cx="2736304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FUMA GENE2FUNC Pathway Analysis of S-</a:t>
            </a:r>
            <a:r>
              <a:rPr lang="en-US" sz="1200" dirty="0" err="1" smtClean="0"/>
              <a:t>Predixcan</a:t>
            </a:r>
            <a:r>
              <a:rPr lang="en-US" sz="1200" dirty="0" smtClean="0"/>
              <a:t> genes</a:t>
            </a:r>
            <a:endParaRPr lang="en-US" sz="1200" dirty="0"/>
          </a:p>
        </p:txBody>
      </p:sp>
      <p:cxnSp>
        <p:nvCxnSpPr>
          <p:cNvPr id="53" name="Straight Arrow Connector 52"/>
          <p:cNvCxnSpPr>
            <a:stCxn id="50" idx="2"/>
            <a:endCxn id="51" idx="0"/>
          </p:cNvCxnSpPr>
          <p:nvPr/>
        </p:nvCxnSpPr>
        <p:spPr>
          <a:xfrm>
            <a:off x="1785429" y="4766593"/>
            <a:ext cx="0" cy="186407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407427" y="6324808"/>
            <a:ext cx="2736304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MAGMA gene based analysis </a:t>
            </a:r>
            <a:endParaRPr lang="en-US" sz="1200" dirty="0"/>
          </a:p>
        </p:txBody>
      </p:sp>
      <p:sp>
        <p:nvSpPr>
          <p:cNvPr id="55" name="Rectangle 54"/>
          <p:cNvSpPr/>
          <p:nvPr/>
        </p:nvSpPr>
        <p:spPr>
          <a:xfrm>
            <a:off x="5351105" y="1424608"/>
            <a:ext cx="1361928" cy="389783"/>
          </a:xfrm>
          <a:prstGeom prst="rect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 err="1" smtClean="0"/>
              <a:t>Edu</a:t>
            </a:r>
            <a:r>
              <a:rPr lang="en-US" sz="1200" dirty="0" smtClean="0"/>
              <a:t>-SZ</a:t>
            </a:r>
            <a:endParaRPr lang="en-SG" sz="1200" dirty="0"/>
          </a:p>
        </p:txBody>
      </p:sp>
      <p:cxnSp>
        <p:nvCxnSpPr>
          <p:cNvPr id="57" name="Straight Arrow Connector 56"/>
          <p:cNvCxnSpPr>
            <a:stCxn id="9" idx="2"/>
            <a:endCxn id="5" idx="0"/>
          </p:cNvCxnSpPr>
          <p:nvPr/>
        </p:nvCxnSpPr>
        <p:spPr>
          <a:xfrm flipH="1">
            <a:off x="968022" y="990945"/>
            <a:ext cx="2460976" cy="434046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>
            <a:stCxn id="9" idx="2"/>
            <a:endCxn id="6" idx="0"/>
          </p:cNvCxnSpPr>
          <p:nvPr/>
        </p:nvCxnSpPr>
        <p:spPr>
          <a:xfrm flipH="1">
            <a:off x="2193464" y="990945"/>
            <a:ext cx="1235534" cy="434046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>
            <a:stCxn id="9" idx="2"/>
            <a:endCxn id="7" idx="0"/>
          </p:cNvCxnSpPr>
          <p:nvPr/>
        </p:nvCxnSpPr>
        <p:spPr>
          <a:xfrm>
            <a:off x="3428998" y="990945"/>
            <a:ext cx="12244" cy="434046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>
            <a:stCxn id="9" idx="2"/>
            <a:endCxn id="8" idx="0"/>
          </p:cNvCxnSpPr>
          <p:nvPr/>
        </p:nvCxnSpPr>
        <p:spPr>
          <a:xfrm>
            <a:off x="3428998" y="990945"/>
            <a:ext cx="1241813" cy="434045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>
            <a:stCxn id="9" idx="2"/>
            <a:endCxn id="55" idx="0"/>
          </p:cNvCxnSpPr>
          <p:nvPr/>
        </p:nvCxnSpPr>
        <p:spPr>
          <a:xfrm>
            <a:off x="3428998" y="990945"/>
            <a:ext cx="2603071" cy="433663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407427" y="8221176"/>
            <a:ext cx="2736304" cy="646331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Results of MAGMA competitive pathway analysis of Drug and Neurodevelopmental Pathways</a:t>
            </a:r>
            <a:endParaRPr lang="en-US" sz="1200" dirty="0"/>
          </a:p>
        </p:txBody>
      </p:sp>
      <p:sp>
        <p:nvSpPr>
          <p:cNvPr id="76" name="TextBox 75"/>
          <p:cNvSpPr txBox="1"/>
          <p:nvPr/>
        </p:nvSpPr>
        <p:spPr>
          <a:xfrm>
            <a:off x="101502" y="7249631"/>
            <a:ext cx="1555815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Drug </a:t>
            </a:r>
            <a:r>
              <a:rPr lang="en-US" sz="1200" smtClean="0"/>
              <a:t>pathway Annotations</a:t>
            </a:r>
            <a:endParaRPr lang="en-US" sz="1200" dirty="0"/>
          </a:p>
        </p:txBody>
      </p:sp>
      <p:sp>
        <p:nvSpPr>
          <p:cNvPr id="77" name="TextBox 76"/>
          <p:cNvSpPr txBox="1"/>
          <p:nvPr/>
        </p:nvSpPr>
        <p:spPr>
          <a:xfrm>
            <a:off x="1753384" y="7249631"/>
            <a:ext cx="1555815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Neurodevelopmental </a:t>
            </a:r>
            <a:r>
              <a:rPr lang="en-US" sz="1200" smtClean="0"/>
              <a:t>pathway annotations</a:t>
            </a:r>
            <a:endParaRPr lang="en-US" sz="1200" dirty="0"/>
          </a:p>
        </p:txBody>
      </p:sp>
      <p:cxnSp>
        <p:nvCxnSpPr>
          <p:cNvPr id="79" name="Straight Arrow Connector 78"/>
          <p:cNvCxnSpPr>
            <a:stCxn id="61" idx="2"/>
            <a:endCxn id="54" idx="0"/>
          </p:cNvCxnSpPr>
          <p:nvPr/>
        </p:nvCxnSpPr>
        <p:spPr>
          <a:xfrm>
            <a:off x="1775579" y="6148836"/>
            <a:ext cx="0" cy="1759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/>
          <p:cNvCxnSpPr>
            <a:stCxn id="54" idx="2"/>
            <a:endCxn id="76" idx="0"/>
          </p:cNvCxnSpPr>
          <p:nvPr/>
        </p:nvCxnSpPr>
        <p:spPr>
          <a:xfrm flipH="1">
            <a:off x="879410" y="6601807"/>
            <a:ext cx="896169" cy="6478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3706931" y="6512601"/>
            <a:ext cx="2718161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LD-Score Regression</a:t>
            </a:r>
            <a:endParaRPr lang="en-US" sz="1200" dirty="0"/>
          </a:p>
        </p:txBody>
      </p:sp>
      <p:sp>
        <p:nvSpPr>
          <p:cNvPr id="49" name="TextBox 48"/>
          <p:cNvSpPr txBox="1"/>
          <p:nvPr/>
        </p:nvSpPr>
        <p:spPr>
          <a:xfrm>
            <a:off x="2620873" y="0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upplementary Figure </a:t>
            </a:r>
            <a:r>
              <a:rPr lang="en-US" sz="1200" b="1" dirty="0"/>
              <a:t>2</a:t>
            </a:r>
            <a:endParaRPr lang="en-SG" sz="1200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4221877" y="2515761"/>
            <a:ext cx="2203215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Annotated via CTD analyzer</a:t>
            </a:r>
            <a:endParaRPr lang="en-US" sz="1200" dirty="0"/>
          </a:p>
        </p:txBody>
      </p:sp>
      <p:cxnSp>
        <p:nvCxnSpPr>
          <p:cNvPr id="56" name="Straight Arrow Connector 55"/>
          <p:cNvCxnSpPr>
            <a:stCxn id="31" idx="2"/>
            <a:endCxn id="52" idx="0"/>
          </p:cNvCxnSpPr>
          <p:nvPr/>
        </p:nvCxnSpPr>
        <p:spPr>
          <a:xfrm flipH="1">
            <a:off x="5323485" y="2362593"/>
            <a:ext cx="1" cy="153168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3484006" y="5703267"/>
            <a:ext cx="3194355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Annotated via CTD analyzer</a:t>
            </a:r>
            <a:endParaRPr lang="en-US" sz="1200" dirty="0"/>
          </a:p>
        </p:txBody>
      </p:sp>
      <p:cxnSp>
        <p:nvCxnSpPr>
          <p:cNvPr id="59" name="Straight Arrow Connector 58"/>
          <p:cNvCxnSpPr>
            <a:stCxn id="46" idx="2"/>
            <a:endCxn id="58" idx="0"/>
          </p:cNvCxnSpPr>
          <p:nvPr/>
        </p:nvCxnSpPr>
        <p:spPr>
          <a:xfrm>
            <a:off x="5073548" y="5513715"/>
            <a:ext cx="7636" cy="189552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07427" y="5687171"/>
            <a:ext cx="2736304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ASSET summary statistics</a:t>
            </a:r>
          </a:p>
          <a:p>
            <a:pPr algn="ctr"/>
            <a:r>
              <a:rPr lang="en-US" sz="1200" dirty="0" smtClean="0"/>
              <a:t>(All subsets)</a:t>
            </a:r>
            <a:endParaRPr lang="en-US" sz="1200" dirty="0"/>
          </a:p>
        </p:txBody>
      </p:sp>
      <p:cxnSp>
        <p:nvCxnSpPr>
          <p:cNvPr id="63" name="Straight Arrow Connector 62"/>
          <p:cNvCxnSpPr>
            <a:stCxn id="54" idx="2"/>
            <a:endCxn id="77" idx="0"/>
          </p:cNvCxnSpPr>
          <p:nvPr/>
        </p:nvCxnSpPr>
        <p:spPr>
          <a:xfrm>
            <a:off x="1775579" y="6601807"/>
            <a:ext cx="755713" cy="6478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>
            <a:stCxn id="77" idx="2"/>
          </p:cNvCxnSpPr>
          <p:nvPr/>
        </p:nvCxnSpPr>
        <p:spPr>
          <a:xfrm flipH="1">
            <a:off x="1785429" y="7711296"/>
            <a:ext cx="745863" cy="50611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>
            <a:stCxn id="76" idx="2"/>
            <a:endCxn id="72" idx="0"/>
          </p:cNvCxnSpPr>
          <p:nvPr/>
        </p:nvCxnSpPr>
        <p:spPr>
          <a:xfrm>
            <a:off x="879410" y="7711296"/>
            <a:ext cx="896169" cy="50988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>
            <a:stCxn id="39" idx="2"/>
            <a:endCxn id="40" idx="0"/>
          </p:cNvCxnSpPr>
          <p:nvPr/>
        </p:nvCxnSpPr>
        <p:spPr>
          <a:xfrm>
            <a:off x="5073549" y="4518803"/>
            <a:ext cx="0" cy="215312"/>
          </a:xfrm>
          <a:prstGeom prst="straightConnector1">
            <a:avLst/>
          </a:prstGeom>
          <a:ln w="31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3537308" y="7263698"/>
            <a:ext cx="840689" cy="646331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/>
              <a:t>ASSET Full Summary Statistics</a:t>
            </a:r>
            <a:endParaRPr lang="en-US" sz="1200" dirty="0"/>
          </a:p>
        </p:txBody>
      </p:sp>
      <p:sp>
        <p:nvSpPr>
          <p:cNvPr id="84" name="TextBox 83"/>
          <p:cNvSpPr txBox="1"/>
          <p:nvPr/>
        </p:nvSpPr>
        <p:spPr>
          <a:xfrm>
            <a:off x="4377997" y="7530448"/>
            <a:ext cx="973417" cy="646331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ASSET Concordant Subset</a:t>
            </a:r>
            <a:endParaRPr lang="en-US" sz="1200" dirty="0"/>
          </a:p>
        </p:txBody>
      </p:sp>
      <p:sp>
        <p:nvSpPr>
          <p:cNvPr id="85" name="TextBox 84"/>
          <p:cNvSpPr txBox="1"/>
          <p:nvPr/>
        </p:nvSpPr>
        <p:spPr>
          <a:xfrm>
            <a:off x="5708674" y="7263140"/>
            <a:ext cx="931394" cy="45812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ASSET Edu-SZ subset</a:t>
            </a:r>
            <a:endParaRPr lang="en-US" sz="1200" dirty="0"/>
          </a:p>
        </p:txBody>
      </p:sp>
      <p:cxnSp>
        <p:nvCxnSpPr>
          <p:cNvPr id="86" name="Straight Arrow Connector 85"/>
          <p:cNvCxnSpPr>
            <a:stCxn id="88" idx="2"/>
            <a:endCxn id="83" idx="0"/>
          </p:cNvCxnSpPr>
          <p:nvPr/>
        </p:nvCxnSpPr>
        <p:spPr>
          <a:xfrm flipH="1">
            <a:off x="3957653" y="6789600"/>
            <a:ext cx="1108359" cy="47409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>
            <a:stCxn id="88" idx="2"/>
            <a:endCxn id="84" idx="0"/>
          </p:cNvCxnSpPr>
          <p:nvPr/>
        </p:nvCxnSpPr>
        <p:spPr>
          <a:xfrm flipH="1">
            <a:off x="4864706" y="6789600"/>
            <a:ext cx="201306" cy="74084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/>
          <p:cNvCxnSpPr>
            <a:stCxn id="88" idx="2"/>
            <a:endCxn id="85" idx="0"/>
          </p:cNvCxnSpPr>
          <p:nvPr/>
        </p:nvCxnSpPr>
        <p:spPr>
          <a:xfrm>
            <a:off x="5066012" y="6789600"/>
            <a:ext cx="1108359" cy="47354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5301208" y="8235751"/>
            <a:ext cx="728451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Edu </a:t>
            </a:r>
            <a:r>
              <a:rPr lang="en-US" sz="1200" smtClean="0"/>
              <a:t>type variants</a:t>
            </a:r>
            <a:endParaRPr lang="en-US" sz="1200" dirty="0" smtClean="0"/>
          </a:p>
        </p:txBody>
      </p:sp>
      <p:sp>
        <p:nvSpPr>
          <p:cNvPr id="101" name="TextBox 100"/>
          <p:cNvSpPr txBox="1"/>
          <p:nvPr/>
        </p:nvSpPr>
        <p:spPr>
          <a:xfrm>
            <a:off x="6042767" y="8548726"/>
            <a:ext cx="708115" cy="478348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Z type variants</a:t>
            </a:r>
          </a:p>
        </p:txBody>
      </p:sp>
      <p:cxnSp>
        <p:nvCxnSpPr>
          <p:cNvPr id="102" name="Straight Arrow Connector 101"/>
          <p:cNvCxnSpPr>
            <a:stCxn id="85" idx="2"/>
            <a:endCxn id="100" idx="0"/>
          </p:cNvCxnSpPr>
          <p:nvPr/>
        </p:nvCxnSpPr>
        <p:spPr>
          <a:xfrm flipH="1">
            <a:off x="5665434" y="7721263"/>
            <a:ext cx="508937" cy="5144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>
            <a:stCxn id="85" idx="2"/>
            <a:endCxn id="101" idx="0"/>
          </p:cNvCxnSpPr>
          <p:nvPr/>
        </p:nvCxnSpPr>
        <p:spPr>
          <a:xfrm>
            <a:off x="6174371" y="7721263"/>
            <a:ext cx="222454" cy="82746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>
            <a:off x="3784419" y="9232460"/>
            <a:ext cx="2718161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Genetic Correlations</a:t>
            </a:r>
            <a:endParaRPr lang="en-US" sz="1200" dirty="0"/>
          </a:p>
        </p:txBody>
      </p:sp>
      <p:cxnSp>
        <p:nvCxnSpPr>
          <p:cNvPr id="116" name="Straight Arrow Connector 115"/>
          <p:cNvCxnSpPr>
            <a:stCxn id="83" idx="2"/>
          </p:cNvCxnSpPr>
          <p:nvPr/>
        </p:nvCxnSpPr>
        <p:spPr>
          <a:xfrm>
            <a:off x="3957653" y="7910029"/>
            <a:ext cx="16903" cy="132243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/>
          <p:cNvCxnSpPr/>
          <p:nvPr/>
        </p:nvCxnSpPr>
        <p:spPr>
          <a:xfrm>
            <a:off x="6382839" y="9029768"/>
            <a:ext cx="13985" cy="20269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/>
          <p:cNvCxnSpPr/>
          <p:nvPr/>
        </p:nvCxnSpPr>
        <p:spPr>
          <a:xfrm>
            <a:off x="5658288" y="8709743"/>
            <a:ext cx="7145" cy="53532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Arrow Connector 121"/>
          <p:cNvCxnSpPr/>
          <p:nvPr/>
        </p:nvCxnSpPr>
        <p:spPr>
          <a:xfrm>
            <a:off x="4856253" y="8176779"/>
            <a:ext cx="8452" cy="108190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51639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3595645"/>
              </p:ext>
            </p:extLst>
          </p:nvPr>
        </p:nvGraphicFramePr>
        <p:xfrm>
          <a:off x="137553" y="258753"/>
          <a:ext cx="6597352" cy="95187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636912" y="56456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Figure </a:t>
            </a:r>
            <a:r>
              <a:rPr lang="en-US" sz="1200" b="1" dirty="0" smtClean="0"/>
              <a:t>3</a:t>
            </a:r>
            <a:endParaRPr lang="en-SG" sz="1200" b="1" dirty="0"/>
          </a:p>
        </p:txBody>
      </p:sp>
    </p:spTree>
    <p:extLst>
      <p:ext uri="{BB962C8B-B14F-4D97-AF65-F5344CB8AC3E}">
        <p14:creationId xmlns:p14="http://schemas.microsoft.com/office/powerpoint/2010/main" val="3786488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791</TotalTime>
  <Words>298</Words>
  <Application>Microsoft Office PowerPoint</Application>
  <PresentationFormat>A4 Paper (210x297 mm)</PresentationFormat>
  <Paragraphs>78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upplementary Figures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Max Lam</dc:creator>
  <cp:lastModifiedBy>Lencz, Todd</cp:lastModifiedBy>
  <cp:revision>211</cp:revision>
  <dcterms:created xsi:type="dcterms:W3CDTF">2018-01-18T19:53:50Z</dcterms:created>
  <dcterms:modified xsi:type="dcterms:W3CDTF">2019-01-18T07:07:44Z</dcterms:modified>
</cp:coreProperties>
</file>